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56" r:id="rId2"/>
    <p:sldId id="257" r:id="rId3"/>
    <p:sldId id="258" r:id="rId4"/>
    <p:sldId id="259" r:id="rId5"/>
    <p:sldId id="260" r:id="rId6"/>
    <p:sldId id="261" r:id="rId7"/>
    <p:sldId id="321" r:id="rId8"/>
    <p:sldId id="262" r:id="rId9"/>
    <p:sldId id="296" r:id="rId10"/>
    <p:sldId id="343" r:id="rId11"/>
    <p:sldId id="263" r:id="rId12"/>
    <p:sldId id="264" r:id="rId13"/>
    <p:sldId id="338" r:id="rId14"/>
    <p:sldId id="339" r:id="rId15"/>
    <p:sldId id="341" r:id="rId16"/>
    <p:sldId id="322" r:id="rId17"/>
    <p:sldId id="323" r:id="rId18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em Estilo, Sem Grelh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450" autoAdjust="0"/>
  </p:normalViewPr>
  <p:slideViewPr>
    <p:cSldViewPr snapToGrid="0">
      <p:cViewPr varScale="1">
        <p:scale>
          <a:sx n="58" d="100"/>
          <a:sy n="58" d="100"/>
        </p:scale>
        <p:origin x="89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C480A-3A01-4B09-9DA1-235E6EDE4A8B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50ABDE-1A30-4608-932E-D30E35E5EBDC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077139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7C75C6-968D-ECD9-2D66-656F229C99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>
            <a:extLst>
              <a:ext uri="{FF2B5EF4-FFF2-40B4-BE49-F238E27FC236}">
                <a16:creationId xmlns:a16="http://schemas.microsoft.com/office/drawing/2014/main" id="{3ADECC7F-06AF-B966-4130-8E80EA7FFC7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>
            <a:extLst>
              <a:ext uri="{FF2B5EF4-FFF2-40B4-BE49-F238E27FC236}">
                <a16:creationId xmlns:a16="http://schemas.microsoft.com/office/drawing/2014/main" id="{02AC8EC4-A33C-93FA-8E92-BCF23845F78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FB792097-2478-F760-FFD2-E3FE03C6B17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50ABDE-1A30-4608-932E-D30E35E5EBDC}" type="slidenum">
              <a:rPr lang="pt-PT" smtClean="0"/>
              <a:t>10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420286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50ABDE-1A30-4608-932E-D30E35E5EBDC}" type="slidenum">
              <a:rPr lang="pt-PT" smtClean="0"/>
              <a:t>13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154427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50ABDE-1A30-4608-932E-D30E35E5EBDC}" type="slidenum">
              <a:rPr lang="pt-PT" smtClean="0"/>
              <a:t>14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951966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50ABDE-1A30-4608-932E-D30E35E5EBDC}" type="slidenum">
              <a:rPr lang="pt-PT" smtClean="0"/>
              <a:t>15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357398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DF12712-9F2B-D58F-E66D-AA84CA827F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C17FE14-B0CB-00EB-3694-8709260ECD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F3EDEF9-454D-1B0A-BACB-FA70617C8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78910FC-7D76-4995-3CE4-6DA2C2342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247B571-4305-8A0F-51D7-4E8BB128A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21227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E9D50D-3D87-FEE2-22E6-85B4B5B232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C51DD3E8-80BE-8080-2DD7-2C1D54C0ED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27EA4CC-3617-AD3B-D56D-72D82B34A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B72FA817-D152-356D-C685-B968A8E52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1CE3E037-D858-23FE-181E-5C3EA688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41726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1BDEF4D-E612-0A54-12E9-6AD724B838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02D75264-7AA3-D72D-8E26-854FBECE25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2613B5C-085E-0A1C-A749-4150E3BE4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51BEAC46-4C44-4CD1-B638-0C7103AE5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01B598E-BF49-88D3-A837-1488D0F02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23243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68E6217-1BA2-DEF6-9469-D9031914A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35291010-21DD-C647-C60C-387DCB296D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4948622-7C3A-0C98-8C48-0F13D23C6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78CE7056-88CB-6BB0-0BF0-0D0B36B93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60D485A-FE17-7055-AA33-DE817AE28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25628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799905-1AD1-387A-6CC5-CD2968B59A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284C3B0A-F43C-0343-520E-5224B28CE2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A2BBF02-F985-2180-999F-56375202A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E5377B5-F93A-42FB-C994-0DC8F4244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C8FCE1A-2FFC-940D-AC05-8C4A7CB27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7319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4D531C-D6AE-D96F-7D27-C26EBDB47B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BB25BB6B-DED3-0955-0042-113A2EADBF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6045BDFB-13DF-972A-960D-822F3BB521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DF30D83E-4A3C-D494-EBE9-B83C6A008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8C7E7866-9260-F4B9-5EB0-A37B3F3EB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4F9957AD-9FCC-BF40-47A6-D799C5E04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95466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B27D24-8F9B-75D8-1196-EA6C2D651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B4244C96-DE7E-EE6F-D4EB-8B4461DEE2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DEFC4E7F-A8E1-E9AD-2C12-3B1CFC53C1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401E4E7F-619B-210B-84C9-7DBA498D84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CAD92E24-DB21-F2B9-7F2A-3F889B3FB0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954B665B-7D8B-6EEF-40E3-A0F0F7C7D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DC58B891-BDA1-752C-5916-F90F2A81A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54E94455-E85A-B7AC-5E6F-271933E29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82791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FA3A46-36D6-18D0-F37C-977AFDB13B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A678235E-A2B9-DE61-0632-F14BEE285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8651A869-E9F7-20B0-5FCC-4308D75BC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328A87FA-EFE6-2048-5B25-1DF3A49BC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98491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1C8C5F07-3D25-3977-1FBD-2866CC8C3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6A9DAA1E-EA68-6B83-0B52-3274490FD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BECB7E13-0728-10DF-2FB0-624AD4E94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34824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624D23-AABA-6326-044E-7D5E80436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1D61C5B6-10A6-8B88-3B7E-BFE03A9D8B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C236A7B1-243B-D7CE-946A-D49B7BA505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A281C25-B8EA-357C-128F-0F0EE1B2B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9667B9A-F25A-5841-2ACD-06D92F80B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CD6AC2C7-AC5C-5754-EC90-85C18ADE1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034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230196F-0DB6-3392-238B-9D9FACF813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1177CA39-7ECC-ED37-072F-575106C0C6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D5B4C771-AD4B-C5FB-BDEA-CC0C76C3E4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1CBD352A-7B4C-4C41-C27B-7971BE205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EFC7FC49-0B6F-547B-FAB3-C0BD7BE31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103A7AD3-A4B1-6A7C-9167-98D719CF4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57401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751D6631-9431-2396-7AC4-2B9902A81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385B97CD-291C-158D-DBE4-E9A74EC33D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6D6E26B7-A0A8-CA2D-D815-4253A72328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2FF6EF-9AFB-424D-9A18-C34E41A1F53D}" type="datetimeFigureOut">
              <a:rPr lang="pt-PT" smtClean="0"/>
              <a:t>20/05/2026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40CF2E8-A35A-091E-EEF7-4F1DB2B582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72E6F98-A3B5-4005-1D0C-2D3454E3C4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84D44C-8E6E-4A4F-973B-41C619C81D8E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07417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24.emf"/><Relationship Id="rId18" Type="http://schemas.openxmlformats.org/officeDocument/2006/relationships/oleObject" Target="../embeddings/oleObject8.bin"/><Relationship Id="rId3" Type="http://schemas.openxmlformats.org/officeDocument/2006/relationships/image" Target="../media/image19.png"/><Relationship Id="rId7" Type="http://schemas.openxmlformats.org/officeDocument/2006/relationships/image" Target="../media/image21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26.emf"/><Relationship Id="rId2" Type="http://schemas.openxmlformats.org/officeDocument/2006/relationships/notesSlide" Target="../notesSlides/notesSlide2.xml"/><Relationship Id="rId16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23.emf"/><Relationship Id="rId5" Type="http://schemas.openxmlformats.org/officeDocument/2006/relationships/image" Target="../media/image20.emf"/><Relationship Id="rId15" Type="http://schemas.openxmlformats.org/officeDocument/2006/relationships/image" Target="../media/image25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27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22.emf"/><Relationship Id="rId14" Type="http://schemas.openxmlformats.org/officeDocument/2006/relationships/oleObject" Target="../embeddings/oleObject6.bin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4.png"/><Relationship Id="rId18" Type="http://schemas.openxmlformats.org/officeDocument/2006/relationships/image" Target="../media/image39.png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33.png"/><Relationship Id="rId17" Type="http://schemas.openxmlformats.org/officeDocument/2006/relationships/image" Target="../media/image38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11" Type="http://schemas.openxmlformats.org/officeDocument/2006/relationships/image" Target="../media/image32.png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36.png"/><Relationship Id="rId10" Type="http://schemas.openxmlformats.org/officeDocument/2006/relationships/image" Target="../media/image31.emf"/><Relationship Id="rId4" Type="http://schemas.openxmlformats.org/officeDocument/2006/relationships/image" Target="../media/image28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35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png"/><Relationship Id="rId9" Type="http://schemas.openxmlformats.org/officeDocument/2006/relationships/image" Target="../media/image46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eg"/><Relationship Id="rId4" Type="http://schemas.openxmlformats.org/officeDocument/2006/relationships/image" Target="../media/image8.ti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83612E99-22B0-0C49-AB5B-8E1571137108}"/>
              </a:ext>
            </a:extLst>
          </p:cNvPr>
          <p:cNvSpPr txBox="1"/>
          <p:nvPr/>
        </p:nvSpPr>
        <p:spPr>
          <a:xfrm>
            <a:off x="262890" y="1375970"/>
            <a:ext cx="11067097" cy="42445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yposaline LUSO mineral water drives murine macrophage polarization towards an anti-inflammatory M2 phenotype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pt-PT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ood </a:t>
            </a:r>
            <a:r>
              <a:rPr lang="pt-PT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cience</a:t>
            </a:r>
            <a:r>
              <a:rPr lang="pt-PT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&amp; </a:t>
            </a:r>
            <a:r>
              <a:rPr lang="pt-PT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utrition</a:t>
            </a:r>
            <a:endParaRPr lang="pt-PT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pt-PT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eatriz Rodrigues, Cláudia Cid, Rosa Resende, </a:t>
            </a:r>
            <a:r>
              <a:rPr lang="pt-PT" sz="14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ylène</a:t>
            </a:r>
            <a:r>
              <a:rPr lang="pt-PT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arrascal, Maria do Céu Sousa, Conceição Egas, Cláudia F. Pereira, Marisa Azul, Maria Teresa Cruz, Rui Soares, Ana Silva.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pt-PT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orresponding</a:t>
            </a: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pt-PT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uthors</a:t>
            </a: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 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r. Ana Silva (PhD): CIBB/CNC. e-mail: anacrs@cnc.uc.pt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r. Rui Soares (MD): Portuguese </a:t>
            </a:r>
            <a:r>
              <a:rPr lang="pt-PT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ncology</a:t>
            </a: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pt-PT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stitute</a:t>
            </a: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pt-PT" sz="14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f</a:t>
            </a:r>
            <a:r>
              <a:rPr lang="pt-PT" sz="14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oimbra. e-mail: rui.soares@uc.pt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pt-PT" sz="1400" dirty="0"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pt-PT" sz="14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pt-PT" sz="14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B328303D-D57A-2C0C-0FC4-1D80B0AC8919}"/>
              </a:ext>
            </a:extLst>
          </p:cNvPr>
          <p:cNvSpPr txBox="1"/>
          <p:nvPr/>
        </p:nvSpPr>
        <p:spPr>
          <a:xfrm>
            <a:off x="5093963" y="400773"/>
            <a:ext cx="23022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orting</a:t>
            </a:r>
            <a:r>
              <a:rPr lang="pt-P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pt-P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044074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910BCF-9E5E-2C1A-DBA6-9E4ED404D50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CaixaDeTexto 57">
            <a:extLst>
              <a:ext uri="{FF2B5EF4-FFF2-40B4-BE49-F238E27FC236}">
                <a16:creationId xmlns:a16="http://schemas.microsoft.com/office/drawing/2014/main" id="{B6E4183E-1258-0DB5-E4E4-EBCBA94F0A94}"/>
              </a:ext>
            </a:extLst>
          </p:cNvPr>
          <p:cNvSpPr txBox="1"/>
          <p:nvPr/>
        </p:nvSpPr>
        <p:spPr>
          <a:xfrm>
            <a:off x="193551" y="28739"/>
            <a:ext cx="25587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7 </a:t>
            </a:r>
            <a:endParaRPr lang="pt-PT" dirty="0"/>
          </a:p>
        </p:txBody>
      </p:sp>
      <p:pic>
        <p:nvPicPr>
          <p:cNvPr id="75" name="Imagem 74">
            <a:extLst>
              <a:ext uri="{FF2B5EF4-FFF2-40B4-BE49-F238E27FC236}">
                <a16:creationId xmlns:a16="http://schemas.microsoft.com/office/drawing/2014/main" id="{4E2D6D1C-933C-591A-62D7-2686FF64C0B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92" r="68979"/>
          <a:stretch/>
        </p:blipFill>
        <p:spPr>
          <a:xfrm>
            <a:off x="8078494" y="4084488"/>
            <a:ext cx="655731" cy="2051188"/>
          </a:xfrm>
          <a:prstGeom prst="rect">
            <a:avLst/>
          </a:prstGeom>
        </p:spPr>
      </p:pic>
      <p:pic>
        <p:nvPicPr>
          <p:cNvPr id="183" name="Imagem 182">
            <a:extLst>
              <a:ext uri="{FF2B5EF4-FFF2-40B4-BE49-F238E27FC236}">
                <a16:creationId xmlns:a16="http://schemas.microsoft.com/office/drawing/2014/main" id="{711B1FA7-A4ED-BC29-D3CC-8F4625F7BF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8179" y="391329"/>
            <a:ext cx="12000607" cy="3037672"/>
          </a:xfrm>
          <a:prstGeom prst="rect">
            <a:avLst/>
          </a:prstGeom>
        </p:spPr>
      </p:pic>
      <p:sp>
        <p:nvSpPr>
          <p:cNvPr id="184" name="CaixaDeTexto 183">
            <a:extLst>
              <a:ext uri="{FF2B5EF4-FFF2-40B4-BE49-F238E27FC236}">
                <a16:creationId xmlns:a16="http://schemas.microsoft.com/office/drawing/2014/main" id="{8B770D46-2725-94C1-2838-9C548467C921}"/>
              </a:ext>
            </a:extLst>
          </p:cNvPr>
          <p:cNvSpPr txBox="1"/>
          <p:nvPr/>
        </p:nvSpPr>
        <p:spPr>
          <a:xfrm>
            <a:off x="8842342" y="4084488"/>
            <a:ext cx="315610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7  </a:t>
            </a:r>
            <a:r>
              <a:rPr lang="en-US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 membranes depicted in the manuscript. 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B </a:t>
            </a:r>
            <a:r>
              <a:rPr lang="pt-P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ages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pt-P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uscript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oppe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rizontally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ipped</a:t>
            </a:r>
            <a:r>
              <a:rPr lang="pt-P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match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der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ph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(C), (D)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) shows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iginal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e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. 5; (B)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, shows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iginal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e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ig. 7.</a:t>
            </a:r>
          </a:p>
        </p:txBody>
      </p:sp>
      <p:pic>
        <p:nvPicPr>
          <p:cNvPr id="186" name="Imagem 185">
            <a:extLst>
              <a:ext uri="{FF2B5EF4-FFF2-40B4-BE49-F238E27FC236}">
                <a16:creationId xmlns:a16="http://schemas.microsoft.com/office/drawing/2014/main" id="{08282DDA-B628-DE71-2878-713F19633B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3551" y="3733317"/>
            <a:ext cx="7977992" cy="3051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54306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2CEB35DB-0003-0E54-061C-D9002781398D}"/>
              </a:ext>
            </a:extLst>
          </p:cNvPr>
          <p:cNvSpPr txBox="1"/>
          <p:nvPr/>
        </p:nvSpPr>
        <p:spPr>
          <a:xfrm>
            <a:off x="3087499" y="4314742"/>
            <a:ext cx="6017001" cy="199811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8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ellular viability (Trypan Blue dye exclusion assay)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ells were plated at a density of 200,000 cells/ml and exposed to LUSO NMW (B and S) for 48 h. Cells were detached using a scrapper and 0.01 mL of 0.4% (w/v) trypan blue stock solution in PBS was added (1:1 ratio). The number of viable and dead cells was counted manually using a Neubauer chamber. Data corresponds to the mean ± SEM of two independent experiments. Statistics: Two-way ANOVA with Tukey's multiple comparisons test. P&lt;0.05 was considered significant. * P&lt;0.05 (compared to Ctr) and ** P&lt;0.01.</a:t>
            </a:r>
            <a:endParaRPr lang="pt-PT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D3A4AF35-E603-0F3C-B875-97080888731E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8 </a:t>
            </a:r>
            <a:endParaRPr lang="pt-PT" dirty="0"/>
          </a:p>
        </p:txBody>
      </p:sp>
      <p:pic>
        <p:nvPicPr>
          <p:cNvPr id="6" name="Imagem 5" descr="Uma imagem com texto, diagrama, file, captura de ecrã&#10;&#10;Descrição gerada automaticamente">
            <a:extLst>
              <a:ext uri="{FF2B5EF4-FFF2-40B4-BE49-F238E27FC236}">
                <a16:creationId xmlns:a16="http://schemas.microsoft.com/office/drawing/2014/main" id="{01EC6FD4-EB44-F5CA-5054-CAEDFBC1F9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1284" y="348598"/>
            <a:ext cx="5209430" cy="3759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12467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FA861BB9-C770-1CA6-BD56-9557C6759C12}"/>
              </a:ext>
            </a:extLst>
          </p:cNvPr>
          <p:cNvSpPr txBox="1"/>
          <p:nvPr/>
        </p:nvSpPr>
        <p:spPr>
          <a:xfrm>
            <a:off x="7328453" y="1841490"/>
            <a:ext cx="4196049" cy="33881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9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l10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d2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gene expression. RT-qPCR analysis of the anti-inflammatory gen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l10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A –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)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the antioxidant gen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d2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D – F) after 6 h and 18 h of LPS incubation. (C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nd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) The graphs depict a comparison between gene expression at 6 h and 18 h. Data correspond to the mean ± SEM of five independent experiments and are normalized to the reference gen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prt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Statistics: One-way ANOVA with Tukey's multiple comparisons test and unpaired t-test (t). P&lt;0.05 was considered significant. ** P&lt;0.01, *** P&lt;0.001 and **** P&lt;0.0001, compared to Ctr; &amp;&amp; P&lt;0.01, &amp;&amp;&amp; P&lt;0.001 and &amp;&amp;&amp;&amp; P&lt;0.0001, compared to the control cells of B and S (without LPS); ## P&lt;0.01, compared to LPS; t P&lt;0.05, compared to 6 h; § P&lt;0.05. </a:t>
            </a:r>
            <a:endParaRPr lang="pt-PT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93BE9FC6-5753-778F-9ABF-46EF22CCE0D3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9 </a:t>
            </a:r>
            <a:endParaRPr lang="pt-PT" dirty="0"/>
          </a:p>
        </p:txBody>
      </p:sp>
      <p:pic>
        <p:nvPicPr>
          <p:cNvPr id="4" name="Imagem 3" descr="Uma imagem com texto, diagrama, file, Paralelo&#10;&#10;Descrição gerada automaticamente">
            <a:extLst>
              <a:ext uri="{FF2B5EF4-FFF2-40B4-BE49-F238E27FC236}">
                <a16:creationId xmlns:a16="http://schemas.microsoft.com/office/drawing/2014/main" id="{40C060BE-85F1-9910-D6C9-CB3B6613E8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968" y="821635"/>
            <a:ext cx="6960967" cy="5784574"/>
          </a:xfrm>
          <a:prstGeom prst="rect">
            <a:avLst/>
          </a:prstGeom>
        </p:spPr>
      </p:pic>
      <p:sp>
        <p:nvSpPr>
          <p:cNvPr id="3" name="Retângulo 2">
            <a:extLst>
              <a:ext uri="{FF2B5EF4-FFF2-40B4-BE49-F238E27FC236}">
                <a16:creationId xmlns:a16="http://schemas.microsoft.com/office/drawing/2014/main" id="{8FF16B04-9070-B832-416E-9377172FB61B}"/>
              </a:ext>
            </a:extLst>
          </p:cNvPr>
          <p:cNvSpPr/>
          <p:nvPr/>
        </p:nvSpPr>
        <p:spPr>
          <a:xfrm>
            <a:off x="243751" y="92854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603237F2-727D-B6B0-2C0E-F00E09731C35}"/>
              </a:ext>
            </a:extLst>
          </p:cNvPr>
          <p:cNvSpPr/>
          <p:nvPr/>
        </p:nvSpPr>
        <p:spPr>
          <a:xfrm>
            <a:off x="2690797" y="92854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BAB9354F-59C4-E0EE-81F7-DD52E7E2EF3D}"/>
              </a:ext>
            </a:extLst>
          </p:cNvPr>
          <p:cNvSpPr/>
          <p:nvPr/>
        </p:nvSpPr>
        <p:spPr>
          <a:xfrm>
            <a:off x="4902366" y="92854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Retângulo 7">
            <a:extLst>
              <a:ext uri="{FF2B5EF4-FFF2-40B4-BE49-F238E27FC236}">
                <a16:creationId xmlns:a16="http://schemas.microsoft.com/office/drawing/2014/main" id="{950B4F21-9995-39D9-1E2E-609B8A32B292}"/>
              </a:ext>
            </a:extLst>
          </p:cNvPr>
          <p:cNvSpPr/>
          <p:nvPr/>
        </p:nvSpPr>
        <p:spPr>
          <a:xfrm>
            <a:off x="280558" y="339804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Retângulo 8">
            <a:extLst>
              <a:ext uri="{FF2B5EF4-FFF2-40B4-BE49-F238E27FC236}">
                <a16:creationId xmlns:a16="http://schemas.microsoft.com/office/drawing/2014/main" id="{4A198538-D836-609C-6D96-D9E011C4C066}"/>
              </a:ext>
            </a:extLst>
          </p:cNvPr>
          <p:cNvSpPr/>
          <p:nvPr/>
        </p:nvSpPr>
        <p:spPr>
          <a:xfrm>
            <a:off x="2690796" y="339804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Retângulo 9">
            <a:extLst>
              <a:ext uri="{FF2B5EF4-FFF2-40B4-BE49-F238E27FC236}">
                <a16:creationId xmlns:a16="http://schemas.microsoft.com/office/drawing/2014/main" id="{5CD0237E-B5C4-DC07-B35F-0C7D552E1A36}"/>
              </a:ext>
            </a:extLst>
          </p:cNvPr>
          <p:cNvSpPr/>
          <p:nvPr/>
        </p:nvSpPr>
        <p:spPr>
          <a:xfrm>
            <a:off x="4889160" y="3429000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7512893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tângulo 14">
            <a:extLst>
              <a:ext uri="{FF2B5EF4-FFF2-40B4-BE49-F238E27FC236}">
                <a16:creationId xmlns:a16="http://schemas.microsoft.com/office/drawing/2014/main" id="{0E0AC2CD-9720-51AD-67D4-76EF489EEAE9}"/>
              </a:ext>
            </a:extLst>
          </p:cNvPr>
          <p:cNvSpPr/>
          <p:nvPr/>
        </p:nvSpPr>
        <p:spPr>
          <a:xfrm>
            <a:off x="34813" y="199158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4" name="Imagem 83">
            <a:extLst>
              <a:ext uri="{FF2B5EF4-FFF2-40B4-BE49-F238E27FC236}">
                <a16:creationId xmlns:a16="http://schemas.microsoft.com/office/drawing/2014/main" id="{B6780E49-1FFC-3E57-6072-E635AC8E08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4839" y="309256"/>
            <a:ext cx="4867583" cy="3335263"/>
          </a:xfrm>
          <a:prstGeom prst="rect">
            <a:avLst/>
          </a:prstGeom>
        </p:spPr>
      </p:pic>
      <p:sp>
        <p:nvSpPr>
          <p:cNvPr id="86" name="CaixaDeTexto 85">
            <a:extLst>
              <a:ext uri="{FF2B5EF4-FFF2-40B4-BE49-F238E27FC236}">
                <a16:creationId xmlns:a16="http://schemas.microsoft.com/office/drawing/2014/main" id="{DC2A57B9-FF18-AB46-C2B4-F6362DF921F5}"/>
              </a:ext>
            </a:extLst>
          </p:cNvPr>
          <p:cNvSpPr txBox="1"/>
          <p:nvPr/>
        </p:nvSpPr>
        <p:spPr>
          <a:xfrm>
            <a:off x="4843187" y="4253814"/>
            <a:ext cx="7185684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0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1 and M2 marker genes in THP-1-derived macrophages exposed to S LUSO NMW. THP-1 cells (ATCC #TIB-202) were seeded at a density of 300,000 cells/mL in a 6 well plate, in RPMI medium prepared with ultrapure water (Ctr) or </a:t>
            </a:r>
            <a:r>
              <a:rPr lang="en-US" sz="1200" i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pring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LUSO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MW (S) and exposed to 5 ng/mL of Phorbol 12-myristate 13-acetate (PMA; Sigma) for 24 h. After, PMA was washed, and the cells were left to rest in fresh media (Ctr or S) for 72 h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) Representative microphotographs of undifferentiated THP-1 cells (Ctr and S, upper panel. Black arrows indicate small clusters of round, suspension cells) and PMA-differentiated THP-1 cells (Ctr and S, PMA lower panel. Red arrows indicate adherent cells, with an oval shape and growing protrusions), at the end of PMA treatment (24 h).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s were acquired in a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tic's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E2000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erted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cope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pt-P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c</a:t>
            </a:r>
            <a:r>
              <a:rPr lang="en-US" sz="12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mera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HD, </a:t>
            </a:r>
            <a:r>
              <a:rPr lang="en-US" sz="12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ticam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6 using the 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otic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Images Plus software (v. 3.0.19.137b). Magnification 40x.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he mRNA levels of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1 marker genes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RF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TAT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CR7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86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M2 marker genes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RC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CD206),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D163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pro-inflammator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L1B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antioxidant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MOX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genes were evaluated by real time RT-PCR (N=1) at the end of the 72 h resting period, and normalized to the reference gene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PRT1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Primer sequences are indicated in the table.</a:t>
            </a:r>
            <a:endParaRPr lang="pt-PT" sz="1200" dirty="0"/>
          </a:p>
        </p:txBody>
      </p:sp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F4A4852E-B908-4F32-DA56-847794774D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7735334"/>
              </p:ext>
            </p:extLst>
          </p:nvPr>
        </p:nvGraphicFramePr>
        <p:xfrm>
          <a:off x="4843187" y="499740"/>
          <a:ext cx="161444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721546" imgH="3033037" progId="Prism8.Document">
                  <p:embed/>
                </p:oleObj>
              </mc:Choice>
              <mc:Fallback>
                <p:oleObj name="Prism 8" r:id="rId4" imgW="2721546" imgH="3033037" progId="Prism8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F4A4852E-B908-4F32-DA56-847794774D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43187" y="499740"/>
                        <a:ext cx="161444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8219886B-DC74-66EA-C2EE-17F4E4577D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5116380"/>
              </p:ext>
            </p:extLst>
          </p:nvPr>
        </p:nvGraphicFramePr>
        <p:xfrm>
          <a:off x="6659747" y="504140"/>
          <a:ext cx="161444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721546" imgH="3033037" progId="Prism8.Document">
                  <p:embed/>
                </p:oleObj>
              </mc:Choice>
              <mc:Fallback>
                <p:oleObj name="Prism 8" r:id="rId6" imgW="2721546" imgH="3033037" progId="Prism8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8219886B-DC74-66EA-C2EE-17F4E4577D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659747" y="504140"/>
                        <a:ext cx="161444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FF703AA4-2D41-B77B-BB3C-EDB4EE7FD1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535577"/>
              </p:ext>
            </p:extLst>
          </p:nvPr>
        </p:nvGraphicFramePr>
        <p:xfrm>
          <a:off x="8497571" y="484749"/>
          <a:ext cx="1542858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600900" imgH="3033037" progId="Prism8.Document">
                  <p:embed/>
                </p:oleObj>
              </mc:Choice>
              <mc:Fallback>
                <p:oleObj name="Prism 8" r:id="rId8" imgW="2600900" imgH="3033037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FF703AA4-2D41-B77B-BB3C-EDB4EE7FD1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497571" y="484749"/>
                        <a:ext cx="1542858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>
            <a:extLst>
              <a:ext uri="{FF2B5EF4-FFF2-40B4-BE49-F238E27FC236}">
                <a16:creationId xmlns:a16="http://schemas.microsoft.com/office/drawing/2014/main" id="{3CC768CC-1C39-8364-36E5-36CBEB0A3B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2552680"/>
              </p:ext>
            </p:extLst>
          </p:nvPr>
        </p:nvGraphicFramePr>
        <p:xfrm>
          <a:off x="10217999" y="465358"/>
          <a:ext cx="1591838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683371" imgH="3033037" progId="Prism8.Document">
                  <p:embed/>
                </p:oleObj>
              </mc:Choice>
              <mc:Fallback>
                <p:oleObj name="Prism 8" r:id="rId10" imgW="2683371" imgH="3033037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3CC768CC-1C39-8364-36E5-36CBEB0A3B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217999" y="465358"/>
                        <a:ext cx="1591838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3CCD9D81-7C0A-6A2E-57C0-918DE21691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4843476"/>
              </p:ext>
            </p:extLst>
          </p:nvPr>
        </p:nvGraphicFramePr>
        <p:xfrm>
          <a:off x="4916488" y="2346325"/>
          <a:ext cx="1546225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607022" imgH="3033037" progId="Prism8.Document">
                  <p:embed/>
                </p:oleObj>
              </mc:Choice>
              <mc:Fallback>
                <p:oleObj name="Prism 8" r:id="rId12" imgW="2607022" imgH="3033037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3CCD9D81-7C0A-6A2E-57C0-918DE21691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916488" y="2346325"/>
                        <a:ext cx="1546225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A74B1390-068D-A21E-D86E-AB95CA192E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1487732"/>
              </p:ext>
            </p:extLst>
          </p:nvPr>
        </p:nvGraphicFramePr>
        <p:xfrm>
          <a:off x="6659747" y="2346399"/>
          <a:ext cx="1591837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683371" imgH="3033037" progId="Prism8.Document">
                  <p:embed/>
                </p:oleObj>
              </mc:Choice>
              <mc:Fallback>
                <p:oleObj name="Prism 8" r:id="rId14" imgW="2683371" imgH="3033037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A74B1390-068D-A21E-D86E-AB95CA192E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6659747" y="2346399"/>
                        <a:ext cx="1591837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o 8">
            <a:extLst>
              <a:ext uri="{FF2B5EF4-FFF2-40B4-BE49-F238E27FC236}">
                <a16:creationId xmlns:a16="http://schemas.microsoft.com/office/drawing/2014/main" id="{12231BFB-DBA4-B96B-BBBD-583130985A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9496814"/>
              </p:ext>
            </p:extLst>
          </p:nvPr>
        </p:nvGraphicFramePr>
        <p:xfrm>
          <a:off x="10162520" y="2346399"/>
          <a:ext cx="1637049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759360" imgH="3033037" progId="Prism8.Document">
                  <p:embed/>
                </p:oleObj>
              </mc:Choice>
              <mc:Fallback>
                <p:oleObj name="Prism 8" r:id="rId16" imgW="2759360" imgH="3033037" progId="Prism8.Document">
                  <p:embed/>
                  <p:pic>
                    <p:nvPicPr>
                      <p:cNvPr id="9" name="Objeto 8">
                        <a:extLst>
                          <a:ext uri="{FF2B5EF4-FFF2-40B4-BE49-F238E27FC236}">
                            <a16:creationId xmlns:a16="http://schemas.microsoft.com/office/drawing/2014/main" id="{12231BFB-DBA4-B96B-BBBD-583130985A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0162520" y="2346399"/>
                        <a:ext cx="1637049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5CABD7A4-AD3F-4A9E-5C5A-11BC997F38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8982205"/>
              </p:ext>
            </p:extLst>
          </p:nvPr>
        </p:nvGraphicFramePr>
        <p:xfrm>
          <a:off x="8508242" y="2346399"/>
          <a:ext cx="1543346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2600900" imgH="3033037" progId="Prism8.Document">
                  <p:embed/>
                </p:oleObj>
              </mc:Choice>
              <mc:Fallback>
                <p:oleObj name="Prism 8" r:id="rId18" imgW="2600900" imgH="3033037" progId="Prism8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5CABD7A4-AD3F-4A9E-5C5A-11BC997F38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508242" y="2346399"/>
                        <a:ext cx="1543346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tângulo 15">
            <a:extLst>
              <a:ext uri="{FF2B5EF4-FFF2-40B4-BE49-F238E27FC236}">
                <a16:creationId xmlns:a16="http://schemas.microsoft.com/office/drawing/2014/main" id="{B5DD4C21-8E02-8192-90B1-33A7B7BD04AA}"/>
              </a:ext>
            </a:extLst>
          </p:cNvPr>
          <p:cNvSpPr/>
          <p:nvPr/>
        </p:nvSpPr>
        <p:spPr>
          <a:xfrm>
            <a:off x="4766147" y="132014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Retângulo 16">
            <a:extLst>
              <a:ext uri="{FF2B5EF4-FFF2-40B4-BE49-F238E27FC236}">
                <a16:creationId xmlns:a16="http://schemas.microsoft.com/office/drawing/2014/main" id="{B6564F37-F0C4-D684-FB15-AB890518AED6}"/>
              </a:ext>
            </a:extLst>
          </p:cNvPr>
          <p:cNvSpPr/>
          <p:nvPr/>
        </p:nvSpPr>
        <p:spPr>
          <a:xfrm>
            <a:off x="4908838" y="536366"/>
            <a:ext cx="7188537" cy="172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8" name="Retângulo 17">
            <a:extLst>
              <a:ext uri="{FF2B5EF4-FFF2-40B4-BE49-F238E27FC236}">
                <a16:creationId xmlns:a16="http://schemas.microsoft.com/office/drawing/2014/main" id="{B7190554-A85E-8077-2EAA-662511C5C29C}"/>
              </a:ext>
            </a:extLst>
          </p:cNvPr>
          <p:cNvSpPr/>
          <p:nvPr/>
        </p:nvSpPr>
        <p:spPr>
          <a:xfrm>
            <a:off x="4906732" y="2376535"/>
            <a:ext cx="3622776" cy="172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9" name="Retângulo 18">
            <a:extLst>
              <a:ext uri="{FF2B5EF4-FFF2-40B4-BE49-F238E27FC236}">
                <a16:creationId xmlns:a16="http://schemas.microsoft.com/office/drawing/2014/main" id="{99CDC0C5-28DE-951E-4495-0F6EA258ECE1}"/>
              </a:ext>
            </a:extLst>
          </p:cNvPr>
          <p:cNvSpPr/>
          <p:nvPr/>
        </p:nvSpPr>
        <p:spPr>
          <a:xfrm>
            <a:off x="8568001" y="2372773"/>
            <a:ext cx="3527267" cy="172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graphicFrame>
        <p:nvGraphicFramePr>
          <p:cNvPr id="20" name="Tabela 19">
            <a:extLst>
              <a:ext uri="{FF2B5EF4-FFF2-40B4-BE49-F238E27FC236}">
                <a16:creationId xmlns:a16="http://schemas.microsoft.com/office/drawing/2014/main" id="{CDC84B41-DEEB-43A8-78EB-BC43C9AEEF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7298562"/>
              </p:ext>
            </p:extLst>
          </p:nvPr>
        </p:nvGraphicFramePr>
        <p:xfrm>
          <a:off x="353191" y="3754617"/>
          <a:ext cx="4361667" cy="2838728"/>
        </p:xfrm>
        <a:graphic>
          <a:graphicData uri="http://schemas.openxmlformats.org/drawingml/2006/table">
            <a:tbl>
              <a:tblPr firstRow="1" firstCol="1" bandRow="1"/>
              <a:tblGrid>
                <a:gridCol w="660658">
                  <a:extLst>
                    <a:ext uri="{9D8B030D-6E8A-4147-A177-3AD203B41FA5}">
                      <a16:colId xmlns:a16="http://schemas.microsoft.com/office/drawing/2014/main" val="3514549988"/>
                    </a:ext>
                  </a:extLst>
                </a:gridCol>
                <a:gridCol w="1825216">
                  <a:extLst>
                    <a:ext uri="{9D8B030D-6E8A-4147-A177-3AD203B41FA5}">
                      <a16:colId xmlns:a16="http://schemas.microsoft.com/office/drawing/2014/main" val="2981796879"/>
                    </a:ext>
                  </a:extLst>
                </a:gridCol>
                <a:gridCol w="1875793">
                  <a:extLst>
                    <a:ext uri="{9D8B030D-6E8A-4147-A177-3AD203B41FA5}">
                      <a16:colId xmlns:a16="http://schemas.microsoft.com/office/drawing/2014/main" val="3734821356"/>
                    </a:ext>
                  </a:extLst>
                </a:gridCol>
              </a:tblGrid>
              <a:tr h="16230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pt-PT" sz="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b="1" kern="100" dirty="0" err="1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Forward</a:t>
                      </a:r>
                      <a:r>
                        <a:rPr lang="pt-PT" sz="800" b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pt-PT" sz="8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Reverse </a:t>
                      </a:r>
                      <a:endParaRPr lang="pt-PT" sz="8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6843374"/>
                  </a:ext>
                </a:extLst>
              </a:tr>
              <a:tr h="277399">
                <a:tc>
                  <a:txBody>
                    <a:bodyPr/>
                    <a:lstStyle/>
                    <a:p>
                      <a:pPr algn="ctr" fontAlgn="ctr"/>
                      <a:r>
                        <a:rPr lang="pt-PT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F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P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5’ GGAAGGGAAATTACCTGAGG 3’ 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TCCAGGTTCATTGAGTAG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813719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STAT1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AATGCTTGCTTGGATCAG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TGATAGGGTCATGTTGCTAG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7570348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CR7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TGGTGATCGGCTTTCTGGT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ACCTTGATGGCCTTGTTG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9188107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D86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AACCTAAGAAGATGAGT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TCCAGAATACAGAAGAT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1246153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MRC1 (CD206)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ACGTGGCTGTGGATAAATAA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AGAAGACGCATGTAAAGCTA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2565203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D163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CTTGGGGTTGTTCTGTTG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ATGGGAATTTTCTGCAAGC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5242561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IL1B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CTTGGTGATGTCTGGT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CTGTAGAGTGGGCTTAT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6209633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MOX1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CCTGAGTTTCAAGTATCC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AACAACAGAACACAACAA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1739560"/>
                  </a:ext>
                </a:extLst>
              </a:tr>
              <a:tr h="2935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i="1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PRT1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TGACACTGGCAAAACAAT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80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’ GGCTTATATCCAACACTTCG 3’</a:t>
                      </a:r>
                    </a:p>
                  </a:txBody>
                  <a:tcPr marL="45166" marR="4516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5902028"/>
                  </a:ext>
                </a:extLst>
              </a:tr>
            </a:tbl>
          </a:graphicData>
        </a:graphic>
      </p:graphicFrame>
      <p:sp>
        <p:nvSpPr>
          <p:cNvPr id="2" name="CaixaDeTexto 1">
            <a:extLst>
              <a:ext uri="{FF2B5EF4-FFF2-40B4-BE49-F238E27FC236}">
                <a16:creationId xmlns:a16="http://schemas.microsoft.com/office/drawing/2014/main" id="{36FA75E3-340E-DA0A-707B-E85D41E5B130}"/>
              </a:ext>
            </a:extLst>
          </p:cNvPr>
          <p:cNvSpPr txBox="1"/>
          <p:nvPr/>
        </p:nvSpPr>
        <p:spPr>
          <a:xfrm>
            <a:off x="0" y="-5489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0 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418924998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tângulo 19">
            <a:extLst>
              <a:ext uri="{FF2B5EF4-FFF2-40B4-BE49-F238E27FC236}">
                <a16:creationId xmlns:a16="http://schemas.microsoft.com/office/drawing/2014/main" id="{1621651A-F573-B39A-3C0C-BF64BD31D4E2}"/>
              </a:ext>
            </a:extLst>
          </p:cNvPr>
          <p:cNvSpPr/>
          <p:nvPr/>
        </p:nvSpPr>
        <p:spPr>
          <a:xfrm>
            <a:off x="-55331" y="319663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56877C14-2401-B523-0AD5-E9F2A681D5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8814605"/>
              </p:ext>
            </p:extLst>
          </p:nvPr>
        </p:nvGraphicFramePr>
        <p:xfrm>
          <a:off x="47872" y="2569013"/>
          <a:ext cx="176659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616026" imgH="3199379" progId="Prism8.Document">
                  <p:embed/>
                </p:oleObj>
              </mc:Choice>
              <mc:Fallback>
                <p:oleObj name="Prism 8" r:id="rId3" imgW="2616026" imgH="3199379" progId="Prism8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56877C14-2401-B523-0AD5-E9F2A681D5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872" y="2569013"/>
                        <a:ext cx="176659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B86317C6-F851-8A6A-3BD3-FE83F7696E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3264597"/>
              </p:ext>
            </p:extLst>
          </p:nvPr>
        </p:nvGraphicFramePr>
        <p:xfrm>
          <a:off x="18157" y="543820"/>
          <a:ext cx="176659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616026" imgH="3199379" progId="Prism8.Document">
                  <p:embed/>
                </p:oleObj>
              </mc:Choice>
              <mc:Fallback>
                <p:oleObj name="Prism 8" r:id="rId5" imgW="2616026" imgH="3199379" progId="Prism8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B86317C6-F851-8A6A-3BD3-FE83F7696E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157" y="543820"/>
                        <a:ext cx="176659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799610D4-7F2A-F986-DCE3-BCC3886252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4824382"/>
              </p:ext>
            </p:extLst>
          </p:nvPr>
        </p:nvGraphicFramePr>
        <p:xfrm>
          <a:off x="1657265" y="2582671"/>
          <a:ext cx="1922026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846513" imgH="3199379" progId="Prism8.Document">
                  <p:embed/>
                </p:oleObj>
              </mc:Choice>
              <mc:Fallback>
                <p:oleObj name="Prism 8" r:id="rId7" imgW="2846513" imgH="3199379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799610D4-7F2A-F986-DCE3-BCC3886252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57265" y="2582671"/>
                        <a:ext cx="1922026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46325FF5-6631-B365-7883-BE81DAE7FE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9752075"/>
              </p:ext>
            </p:extLst>
          </p:nvPr>
        </p:nvGraphicFramePr>
        <p:xfrm>
          <a:off x="1708720" y="557102"/>
          <a:ext cx="1870571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770164" imgH="3199379" progId="Prism8.Document">
                  <p:embed/>
                </p:oleObj>
              </mc:Choice>
              <mc:Fallback>
                <p:oleObj name="Prism 8" r:id="rId9" imgW="2770164" imgH="3199379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46325FF5-6631-B365-7883-BE81DAE7FE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08720" y="557102"/>
                        <a:ext cx="1870571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aixaDeTexto 9">
            <a:extLst>
              <a:ext uri="{FF2B5EF4-FFF2-40B4-BE49-F238E27FC236}">
                <a16:creationId xmlns:a16="http://schemas.microsoft.com/office/drawing/2014/main" id="{9FF35A3A-D8AC-6275-7D17-F942A56D52F5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1 (A-B) </a:t>
            </a:r>
            <a:endParaRPr lang="pt-PT" dirty="0"/>
          </a:p>
        </p:txBody>
      </p:sp>
      <p:pic>
        <p:nvPicPr>
          <p:cNvPr id="11" name="Imagem 10">
            <a:extLst>
              <a:ext uri="{FF2B5EF4-FFF2-40B4-BE49-F238E27FC236}">
                <a16:creationId xmlns:a16="http://schemas.microsoft.com/office/drawing/2014/main" id="{D88787FD-EA58-2341-B8EE-E430E8100FF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689222" y="2708137"/>
            <a:ext cx="1800000" cy="1800000"/>
          </a:xfrm>
          <a:prstGeom prst="rect">
            <a:avLst/>
          </a:prstGeom>
        </p:spPr>
      </p:pic>
      <p:pic>
        <p:nvPicPr>
          <p:cNvPr id="12" name="Imagem 11">
            <a:extLst>
              <a:ext uri="{FF2B5EF4-FFF2-40B4-BE49-F238E27FC236}">
                <a16:creationId xmlns:a16="http://schemas.microsoft.com/office/drawing/2014/main" id="{6CFD90B5-7347-2E72-B504-CFCB3015C0B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54751" y="2708137"/>
            <a:ext cx="1800000" cy="1800000"/>
          </a:xfrm>
          <a:prstGeom prst="rect">
            <a:avLst/>
          </a:prstGeom>
        </p:spPr>
      </p:pic>
      <p:pic>
        <p:nvPicPr>
          <p:cNvPr id="13" name="Imagem 12">
            <a:extLst>
              <a:ext uri="{FF2B5EF4-FFF2-40B4-BE49-F238E27FC236}">
                <a16:creationId xmlns:a16="http://schemas.microsoft.com/office/drawing/2014/main" id="{FF822C95-3CAB-9A89-8D68-5CEB1C07226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889222" y="2708137"/>
            <a:ext cx="1800000" cy="1800000"/>
          </a:xfrm>
          <a:prstGeom prst="rect">
            <a:avLst/>
          </a:prstGeom>
        </p:spPr>
      </p:pic>
      <p:pic>
        <p:nvPicPr>
          <p:cNvPr id="14" name="Imagem 13">
            <a:extLst>
              <a:ext uri="{FF2B5EF4-FFF2-40B4-BE49-F238E27FC236}">
                <a16:creationId xmlns:a16="http://schemas.microsoft.com/office/drawing/2014/main" id="{77C0403F-C4CA-756A-4DD7-D47C705D142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496947" y="2708137"/>
            <a:ext cx="1800000" cy="1800000"/>
          </a:xfrm>
          <a:prstGeom prst="rect">
            <a:avLst/>
          </a:prstGeom>
        </p:spPr>
      </p:pic>
      <p:pic>
        <p:nvPicPr>
          <p:cNvPr id="15" name="Imagem 14">
            <a:extLst>
              <a:ext uri="{FF2B5EF4-FFF2-40B4-BE49-F238E27FC236}">
                <a16:creationId xmlns:a16="http://schemas.microsoft.com/office/drawing/2014/main" id="{DD3AD308-7906-4ACC-FFCD-BFBB2E65353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720689" y="660987"/>
            <a:ext cx="1800000" cy="1800000"/>
          </a:xfrm>
          <a:prstGeom prst="rect">
            <a:avLst/>
          </a:prstGeom>
        </p:spPr>
      </p:pic>
      <p:pic>
        <p:nvPicPr>
          <p:cNvPr id="16" name="Imagem 15">
            <a:extLst>
              <a:ext uri="{FF2B5EF4-FFF2-40B4-BE49-F238E27FC236}">
                <a16:creationId xmlns:a16="http://schemas.microsoft.com/office/drawing/2014/main" id="{CF94C3EE-BA09-E923-E84B-D498BC12518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44431" y="660987"/>
            <a:ext cx="1800000" cy="1800000"/>
          </a:xfrm>
          <a:prstGeom prst="rect">
            <a:avLst/>
          </a:prstGeom>
        </p:spPr>
      </p:pic>
      <p:pic>
        <p:nvPicPr>
          <p:cNvPr id="17" name="Imagem 16">
            <a:extLst>
              <a:ext uri="{FF2B5EF4-FFF2-40B4-BE49-F238E27FC236}">
                <a16:creationId xmlns:a16="http://schemas.microsoft.com/office/drawing/2014/main" id="{DAE8064C-B5A3-313F-A79A-1307F3EED42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920689" y="660987"/>
            <a:ext cx="1800000" cy="1800000"/>
          </a:xfrm>
          <a:prstGeom prst="rect">
            <a:avLst/>
          </a:prstGeom>
        </p:spPr>
      </p:pic>
      <p:pic>
        <p:nvPicPr>
          <p:cNvPr id="18" name="Imagem 17">
            <a:extLst>
              <a:ext uri="{FF2B5EF4-FFF2-40B4-BE49-F238E27FC236}">
                <a16:creationId xmlns:a16="http://schemas.microsoft.com/office/drawing/2014/main" id="{0CCF8E7D-8EF2-4565-7EB7-C5F2328FC2B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496947" y="660987"/>
            <a:ext cx="1800000" cy="1800000"/>
          </a:xfrm>
          <a:prstGeom prst="rect">
            <a:avLst/>
          </a:prstGeom>
        </p:spPr>
      </p:pic>
      <p:sp>
        <p:nvSpPr>
          <p:cNvPr id="19" name="Retângulo 18">
            <a:extLst>
              <a:ext uri="{FF2B5EF4-FFF2-40B4-BE49-F238E27FC236}">
                <a16:creationId xmlns:a16="http://schemas.microsoft.com/office/drawing/2014/main" id="{5BC8DA17-52A2-644C-20CC-73C0ABEF8C20}"/>
              </a:ext>
            </a:extLst>
          </p:cNvPr>
          <p:cNvSpPr/>
          <p:nvPr/>
        </p:nvSpPr>
        <p:spPr>
          <a:xfrm>
            <a:off x="3600145" y="326894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B2235CB6-D043-3762-5BB5-954CCC1F514A}"/>
              </a:ext>
            </a:extLst>
          </p:cNvPr>
          <p:cNvSpPr txBox="1"/>
          <p:nvPr/>
        </p:nvSpPr>
        <p:spPr>
          <a:xfrm>
            <a:off x="4383740" y="327995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pt-P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68CECBA1-89DA-E9BD-DC33-C766C2AC7C6D}"/>
              </a:ext>
            </a:extLst>
          </p:cNvPr>
          <p:cNvSpPr txBox="1"/>
          <p:nvPr/>
        </p:nvSpPr>
        <p:spPr>
          <a:xfrm rot="16200000">
            <a:off x="3245219" y="1360145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B21925B8-920E-C26E-445B-ED4B8A671D1D}"/>
              </a:ext>
            </a:extLst>
          </p:cNvPr>
          <p:cNvSpPr txBox="1"/>
          <p:nvPr/>
        </p:nvSpPr>
        <p:spPr>
          <a:xfrm rot="16200000">
            <a:off x="3245219" y="3395133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0A2E4D73-FCBB-4641-36AF-3AD9155BF3C7}"/>
              </a:ext>
            </a:extLst>
          </p:cNvPr>
          <p:cNvSpPr txBox="1"/>
          <p:nvPr/>
        </p:nvSpPr>
        <p:spPr>
          <a:xfrm>
            <a:off x="6183588" y="327995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ED9FFDB9-E947-5980-51E0-4BC672220FEB}"/>
              </a:ext>
            </a:extLst>
          </p:cNvPr>
          <p:cNvSpPr txBox="1"/>
          <p:nvPr/>
        </p:nvSpPr>
        <p:spPr>
          <a:xfrm>
            <a:off x="7983436" y="327995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ocktail</a:t>
            </a: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C2F52201-564B-8FE1-3755-64B2EBE63135}"/>
              </a:ext>
            </a:extLst>
          </p:cNvPr>
          <p:cNvSpPr txBox="1"/>
          <p:nvPr/>
        </p:nvSpPr>
        <p:spPr>
          <a:xfrm>
            <a:off x="9763280" y="327995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+Cocktail</a:t>
            </a:r>
            <a:endParaRPr lang="pt-P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827565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m 1">
            <a:extLst>
              <a:ext uri="{FF2B5EF4-FFF2-40B4-BE49-F238E27FC236}">
                <a16:creationId xmlns:a16="http://schemas.microsoft.com/office/drawing/2014/main" id="{8ABF9A1F-8CE7-6B1B-2D88-9B1EB5727A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8442" y="2801310"/>
            <a:ext cx="1820526" cy="1800000"/>
          </a:xfrm>
          <a:prstGeom prst="rect">
            <a:avLst/>
          </a:prstGeom>
        </p:spPr>
      </p:pic>
      <p:pic>
        <p:nvPicPr>
          <p:cNvPr id="4" name="Imagem 3">
            <a:extLst>
              <a:ext uri="{FF2B5EF4-FFF2-40B4-BE49-F238E27FC236}">
                <a16:creationId xmlns:a16="http://schemas.microsoft.com/office/drawing/2014/main" id="{FD9DFCFE-C07D-C30B-4283-8D4168F767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28442" y="928770"/>
            <a:ext cx="1820526" cy="1800000"/>
          </a:xfrm>
          <a:prstGeom prst="rect">
            <a:avLst/>
          </a:prstGeom>
        </p:spPr>
      </p:pic>
      <p:pic>
        <p:nvPicPr>
          <p:cNvPr id="5" name="Imagem 4">
            <a:extLst>
              <a:ext uri="{FF2B5EF4-FFF2-40B4-BE49-F238E27FC236}">
                <a16:creationId xmlns:a16="http://schemas.microsoft.com/office/drawing/2014/main" id="{6A6522B6-32EA-B720-BBE7-44B21D365B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8968" y="2801310"/>
            <a:ext cx="1800000" cy="1800000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633EAB75-1FD1-0AA7-8A4C-BA2559FC9E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48968" y="928770"/>
            <a:ext cx="1800000" cy="1800000"/>
          </a:xfrm>
          <a:prstGeom prst="rect">
            <a:avLst/>
          </a:prstGeom>
        </p:spPr>
      </p:pic>
      <p:sp>
        <p:nvSpPr>
          <p:cNvPr id="7" name="Retângulo 6">
            <a:extLst>
              <a:ext uri="{FF2B5EF4-FFF2-40B4-BE49-F238E27FC236}">
                <a16:creationId xmlns:a16="http://schemas.microsoft.com/office/drawing/2014/main" id="{EF9BF0B2-DE78-A8C0-7FC3-DC6311378DC5}"/>
              </a:ext>
            </a:extLst>
          </p:cNvPr>
          <p:cNvSpPr/>
          <p:nvPr/>
        </p:nvSpPr>
        <p:spPr>
          <a:xfrm>
            <a:off x="2116167" y="364268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8" name="Imagem 7">
            <a:extLst>
              <a:ext uri="{FF2B5EF4-FFF2-40B4-BE49-F238E27FC236}">
                <a16:creationId xmlns:a16="http://schemas.microsoft.com/office/drawing/2014/main" id="{A32E5CFA-D1DD-9C9D-8324-7097F3EA5E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48968" y="2801310"/>
            <a:ext cx="1800000" cy="1800000"/>
          </a:xfrm>
          <a:prstGeom prst="rect">
            <a:avLst/>
          </a:prstGeom>
        </p:spPr>
      </p:pic>
      <p:pic>
        <p:nvPicPr>
          <p:cNvPr id="9" name="Imagem 8">
            <a:extLst>
              <a:ext uri="{FF2B5EF4-FFF2-40B4-BE49-F238E27FC236}">
                <a16:creationId xmlns:a16="http://schemas.microsoft.com/office/drawing/2014/main" id="{1B8EE9D4-B645-68C9-4887-BD80D9C519E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48968" y="928770"/>
            <a:ext cx="1800000" cy="1800000"/>
          </a:xfrm>
          <a:prstGeom prst="rect">
            <a:avLst/>
          </a:prstGeom>
        </p:spPr>
      </p:pic>
      <p:pic>
        <p:nvPicPr>
          <p:cNvPr id="10" name="Imagem 9">
            <a:extLst>
              <a:ext uri="{FF2B5EF4-FFF2-40B4-BE49-F238E27FC236}">
                <a16:creationId xmlns:a16="http://schemas.microsoft.com/office/drawing/2014/main" id="{14A9F9FD-83E5-C2DA-0023-F2AE526D98D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978287" y="928770"/>
            <a:ext cx="1800000" cy="1800000"/>
          </a:xfrm>
          <a:prstGeom prst="rect">
            <a:avLst/>
          </a:prstGeom>
        </p:spPr>
      </p:pic>
      <p:pic>
        <p:nvPicPr>
          <p:cNvPr id="11" name="Imagem 10">
            <a:extLst>
              <a:ext uri="{FF2B5EF4-FFF2-40B4-BE49-F238E27FC236}">
                <a16:creationId xmlns:a16="http://schemas.microsoft.com/office/drawing/2014/main" id="{3063921D-A06D-9BAF-FBD2-9828044BA94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983052" y="2801310"/>
            <a:ext cx="1800000" cy="1800000"/>
          </a:xfrm>
          <a:prstGeom prst="rect">
            <a:avLst/>
          </a:prstGeom>
        </p:spPr>
      </p:pic>
      <p:sp>
        <p:nvSpPr>
          <p:cNvPr id="12" name="CaixaDeTexto 11">
            <a:extLst>
              <a:ext uri="{FF2B5EF4-FFF2-40B4-BE49-F238E27FC236}">
                <a16:creationId xmlns:a16="http://schemas.microsoft.com/office/drawing/2014/main" id="{34C73D82-7F44-1FC0-851D-860BAC0F4701}"/>
              </a:ext>
            </a:extLst>
          </p:cNvPr>
          <p:cNvSpPr txBox="1"/>
          <p:nvPr/>
        </p:nvSpPr>
        <p:spPr>
          <a:xfrm>
            <a:off x="2832546" y="579231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tr</a:t>
            </a:r>
            <a:endParaRPr lang="pt-P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CAD891A9-27FF-FF36-B630-71FF59DE7B10}"/>
              </a:ext>
            </a:extLst>
          </p:cNvPr>
          <p:cNvSpPr txBox="1"/>
          <p:nvPr/>
        </p:nvSpPr>
        <p:spPr>
          <a:xfrm rot="16200000">
            <a:off x="1694025" y="1611381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FE800084-9737-B399-C6C2-AA034AA467EA}"/>
              </a:ext>
            </a:extLst>
          </p:cNvPr>
          <p:cNvSpPr txBox="1"/>
          <p:nvPr/>
        </p:nvSpPr>
        <p:spPr>
          <a:xfrm rot="16200000">
            <a:off x="1694025" y="3511894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D86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AF96FF5B-66AB-B019-C710-C4C338F82775}"/>
              </a:ext>
            </a:extLst>
          </p:cNvPr>
          <p:cNvSpPr txBox="1"/>
          <p:nvPr/>
        </p:nvSpPr>
        <p:spPr>
          <a:xfrm>
            <a:off x="4632394" y="579231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388B5B1D-5742-A800-CF1D-E8A68702009F}"/>
              </a:ext>
            </a:extLst>
          </p:cNvPr>
          <p:cNvSpPr txBox="1"/>
          <p:nvPr/>
        </p:nvSpPr>
        <p:spPr>
          <a:xfrm>
            <a:off x="6432242" y="579231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Cocktail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1A0F40BA-9E8E-B86B-476D-45D7BBA8F01E}"/>
              </a:ext>
            </a:extLst>
          </p:cNvPr>
          <p:cNvSpPr txBox="1"/>
          <p:nvPr/>
        </p:nvSpPr>
        <p:spPr>
          <a:xfrm>
            <a:off x="8212086" y="579231"/>
            <a:ext cx="1440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pt-PT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+Cocktail</a:t>
            </a:r>
            <a:endParaRPr lang="pt-PT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30577B4B-0AB2-0477-7F47-93A278489416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1 (C) </a:t>
            </a:r>
            <a:endParaRPr lang="pt-PT" dirty="0"/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C93EA460-3538-014A-343B-B31868F932A4}"/>
              </a:ext>
            </a:extLst>
          </p:cNvPr>
          <p:cNvSpPr txBox="1"/>
          <p:nvPr/>
        </p:nvSpPr>
        <p:spPr>
          <a:xfrm>
            <a:off x="152968" y="4743220"/>
            <a:ext cx="1148649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1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pression of the M2 marker CD163 and M1 marker CD86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 human macrophages exposed to S LUSO NMW. Peripheral blood mononuclear cells (PBMCs) were isolated from buffy coats of healthy donors, kindly provided by the Portuguese Institute of Blood and Transplantation. CD14+ monocytes were obtained using anti-CD14 magnetic bead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iolegend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ccording to the manufacturer's instructions and differentiated into macrophages using 100 ng/mL of granulocyte-macrophage colony-stimulating factor (GM-CSF; Cell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ignalling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echnology) for 6 days. The cells were seeded in RPMI culture medium (Sigma), for the first three days. After, 50% of the medium was changed with fresh RPMI medium, prepared with ultrapure water (Ctr) or Spring LUSO NMW (S). After three days, macrophages were incubated with a pro-inflammatory cocktail composed by 5 µg/mL LPS, INF-γ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eprotech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TNF-α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eprotech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both at 100 ng/mL, for 48 h (Cocktail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+Cocktail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. The cells were further collected and stained 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with CD163-APC (</a:t>
            </a:r>
            <a:r>
              <a:rPr lang="en-US" sz="12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iolegend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d CD86-PE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iolegend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ntibodies and analyzed by flow cytometry</a:t>
            </a:r>
            <a:r>
              <a:rPr lang="en-US" sz="12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(A) Graphical representation of flow cytometry analysis (% of positive cells and MFI; N=1). (B) Representative dot plots of the experiment. (C)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dot plots of unstained cell populations used to gate positive stained cells.</a:t>
            </a:r>
            <a:endParaRPr lang="pt-PT" sz="1200" dirty="0"/>
          </a:p>
        </p:txBody>
      </p:sp>
    </p:spTree>
    <p:extLst>
      <p:ext uri="{BB962C8B-B14F-4D97-AF65-F5344CB8AC3E}">
        <p14:creationId xmlns:p14="http://schemas.microsoft.com/office/powerpoint/2010/main" val="344329916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736230B7-8BB5-EBAD-301B-FC0D59791AD1}"/>
              </a:ext>
            </a:extLst>
          </p:cNvPr>
          <p:cNvGraphicFramePr>
            <a:graphicFrameLocks noGrp="1"/>
          </p:cNvGraphicFramePr>
          <p:nvPr/>
        </p:nvGraphicFramePr>
        <p:xfrm>
          <a:off x="1929447" y="873214"/>
          <a:ext cx="5088573" cy="536756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914702">
                  <a:extLst>
                    <a:ext uri="{9D8B030D-6E8A-4147-A177-3AD203B41FA5}">
                      <a16:colId xmlns:a16="http://schemas.microsoft.com/office/drawing/2014/main" val="1977593757"/>
                    </a:ext>
                  </a:extLst>
                </a:gridCol>
                <a:gridCol w="1049029">
                  <a:extLst>
                    <a:ext uri="{9D8B030D-6E8A-4147-A177-3AD203B41FA5}">
                      <a16:colId xmlns:a16="http://schemas.microsoft.com/office/drawing/2014/main" val="2781327829"/>
                    </a:ext>
                  </a:extLst>
                </a:gridCol>
                <a:gridCol w="1124842">
                  <a:extLst>
                    <a:ext uri="{9D8B030D-6E8A-4147-A177-3AD203B41FA5}">
                      <a16:colId xmlns:a16="http://schemas.microsoft.com/office/drawing/2014/main" val="2925952162"/>
                    </a:ext>
                  </a:extLst>
                </a:gridCol>
              </a:tblGrid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SO NMW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b="1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ttle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ring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3488401"/>
                  </a:ext>
                </a:extLst>
              </a:tr>
              <a:tr h="24398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ysicochemical constants and chemical composition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3464830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 (at 18.5 ºC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614329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alkalinity (mg CaCO</a:t>
                      </a:r>
                      <a:r>
                        <a:rPr lang="en-US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057024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hardness (mg CaCO</a:t>
                      </a:r>
                      <a:r>
                        <a:rPr lang="en-US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6637959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lica (mg SiO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5574198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y residue at 180 ºC (mg/l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2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4957530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pt-PT" sz="12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eralization</a:t>
                      </a: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g/l) 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7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3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4226102"/>
                  </a:ext>
                </a:extLst>
              </a:tr>
              <a:tr h="24398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b="1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ons</a:t>
                      </a:r>
                      <a:r>
                        <a:rPr lang="pt-PT" sz="12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g/l)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6112701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carbonate (HCO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8937503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ide</a:t>
                      </a: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l</a:t>
                      </a:r>
                      <a:r>
                        <a:rPr lang="pt-PT" sz="12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248926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oride (F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8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8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236917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trates (NO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4634707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itrites (NO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3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019307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phate (SO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8638648"/>
                  </a:ext>
                </a:extLst>
              </a:tr>
              <a:tr h="24398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b="1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ions</a:t>
                      </a:r>
                      <a:r>
                        <a:rPr lang="pt-PT" sz="12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mg/l)</a:t>
                      </a:r>
                      <a:endParaRPr lang="pt-PT" sz="1200" b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P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8050864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monium (NH</a:t>
                      </a:r>
                      <a:r>
                        <a:rPr lang="pt-PT" sz="1200" kern="100" baseline="-25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3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1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8246203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lcium (Ca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8041030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on (Fe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5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463180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gnesium (Mg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8085158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tassium (K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3635728"/>
                  </a:ext>
                </a:extLst>
              </a:tr>
              <a:tr h="2439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ium (Na</a:t>
                      </a:r>
                      <a:r>
                        <a:rPr lang="pt-PT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" marR="4445" marT="44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950261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FA2CE2D8-B5CA-FBBE-1F65-C6E0031ED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0758" y="471939"/>
            <a:ext cx="700881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t-P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1</a:t>
            </a:r>
            <a:r>
              <a:rPr kumimoji="0" lang="en-US" altLang="pt-PT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- Luso NMW physicochemical composition according to the certified analytical reports of 2023.</a:t>
            </a:r>
            <a:endParaRPr kumimoji="0" lang="pt-PT" altLang="pt-PT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07896230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5E17547E-F6B1-90ED-4698-0BFF1BFA7FBA}"/>
              </a:ext>
            </a:extLst>
          </p:cNvPr>
          <p:cNvGraphicFramePr>
            <a:graphicFrameLocks noGrp="1"/>
          </p:cNvGraphicFramePr>
          <p:nvPr/>
        </p:nvGraphicFramePr>
        <p:xfrm>
          <a:off x="791554" y="1105536"/>
          <a:ext cx="7172271" cy="437901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52212">
                  <a:extLst>
                    <a:ext uri="{9D8B030D-6E8A-4147-A177-3AD203B41FA5}">
                      <a16:colId xmlns:a16="http://schemas.microsoft.com/office/drawing/2014/main" val="1943778408"/>
                    </a:ext>
                  </a:extLst>
                </a:gridCol>
                <a:gridCol w="3588598">
                  <a:extLst>
                    <a:ext uri="{9D8B030D-6E8A-4147-A177-3AD203B41FA5}">
                      <a16:colId xmlns:a16="http://schemas.microsoft.com/office/drawing/2014/main" val="2736654768"/>
                    </a:ext>
                  </a:extLst>
                </a:gridCol>
                <a:gridCol w="2631461">
                  <a:extLst>
                    <a:ext uri="{9D8B030D-6E8A-4147-A177-3AD203B41FA5}">
                      <a16:colId xmlns:a16="http://schemas.microsoft.com/office/drawing/2014/main" val="3009666610"/>
                    </a:ext>
                  </a:extLst>
                </a:gridCol>
              </a:tblGrid>
              <a:tr h="21374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962459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rt1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TTGAAGATATAATTGACACTG 3'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GCATATCCAACAACAAAC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165134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s2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CATCAACCAGTATTATGGCTC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TTTCCTTTGTTACAGCTTCC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7103036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b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GATGATGATAACCTGC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CATGGAGAATATCACTTGTTGG 3'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0868266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6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AAGAAATGATGGATGCTACC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AGTTTCTGTATCTCTGAAG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3011225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GGATGAGAAGTTCCCAAATG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' TGAGAAGATGATCTGAGTGTG 3'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8751267"/>
                  </a:ext>
                </a:extLst>
              </a:tr>
              <a:tr h="68959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pt-PT" sz="1200" i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ox1</a:t>
                      </a:r>
                      <a:endParaRPr lang="pt-PT" sz="1200" i="1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CCAGTTCTACCAGAGTAA 3’</a:t>
                      </a:r>
                      <a:endParaRPr lang="pt-PT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’ ACAGAAGTTAGAGACCAA 3’</a:t>
                      </a:r>
                      <a:endParaRPr lang="pt-PT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9481" marR="59481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5738460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0B2901A4-BB4A-D4C2-02D7-84B31328C5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7289" y="570670"/>
            <a:ext cx="364040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pt-PT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2.</a:t>
            </a:r>
            <a:r>
              <a:rPr kumimoji="0" lang="en-US" altLang="pt-PT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List of primers</a:t>
            </a:r>
            <a:endParaRPr kumimoji="0" lang="en-US" altLang="pt-PT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077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CCEE8568-5741-3964-D5C5-7AF27DCE0AC7}"/>
              </a:ext>
            </a:extLst>
          </p:cNvPr>
          <p:cNvSpPr txBox="1"/>
          <p:nvPr/>
        </p:nvSpPr>
        <p:spPr>
          <a:xfrm>
            <a:off x="821635" y="6114120"/>
            <a:ext cx="10813773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M1 and M2 phenotype assessed by flow cytometry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epresentative dot plots of unstained cell populations (Ctr, B and S) not exposed to LPS (A) and exposed to LPS (B) used to gate positive stained cells.</a:t>
            </a:r>
            <a:endParaRPr lang="pt-PT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m 6" descr="Uma imagem com texto, diagrama, Gráfico&#10;&#10;Descrição gerada automaticamente">
            <a:extLst>
              <a:ext uri="{FF2B5EF4-FFF2-40B4-BE49-F238E27FC236}">
                <a16:creationId xmlns:a16="http://schemas.microsoft.com/office/drawing/2014/main" id="{DFE04F45-A365-D006-5E9B-7714EC3944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0661" y="418705"/>
            <a:ext cx="10389704" cy="5713696"/>
          </a:xfrm>
          <a:prstGeom prst="rect">
            <a:avLst/>
          </a:prstGeom>
        </p:spPr>
      </p:pic>
      <p:sp>
        <p:nvSpPr>
          <p:cNvPr id="9" name="CaixaDeTexto 8">
            <a:extLst>
              <a:ext uri="{FF2B5EF4-FFF2-40B4-BE49-F238E27FC236}">
                <a16:creationId xmlns:a16="http://schemas.microsoft.com/office/drawing/2014/main" id="{5CC01DEE-755C-28AE-19E4-84D2E709B942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1 </a:t>
            </a:r>
            <a:endParaRPr lang="pt-PT" dirty="0"/>
          </a:p>
        </p:txBody>
      </p:sp>
      <p:sp>
        <p:nvSpPr>
          <p:cNvPr id="2" name="Retângulo 1">
            <a:extLst>
              <a:ext uri="{FF2B5EF4-FFF2-40B4-BE49-F238E27FC236}">
                <a16:creationId xmlns:a16="http://schemas.microsoft.com/office/drawing/2014/main" id="{AB53D5BC-26D7-552B-0F6F-20FEAFDDA523}"/>
              </a:ext>
            </a:extLst>
          </p:cNvPr>
          <p:cNvSpPr/>
          <p:nvPr/>
        </p:nvSpPr>
        <p:spPr>
          <a:xfrm>
            <a:off x="913755" y="356267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44401AB7-9984-5319-14AC-A8B923FD4E7A}"/>
              </a:ext>
            </a:extLst>
          </p:cNvPr>
          <p:cNvSpPr/>
          <p:nvPr/>
        </p:nvSpPr>
        <p:spPr>
          <a:xfrm>
            <a:off x="6315874" y="356267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9481706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ixaDeTexto 2">
            <a:extLst>
              <a:ext uri="{FF2B5EF4-FFF2-40B4-BE49-F238E27FC236}">
                <a16:creationId xmlns:a16="http://schemas.microsoft.com/office/drawing/2014/main" id="{AF0E524D-9474-1615-DE93-CEFDE99A2384}"/>
              </a:ext>
            </a:extLst>
          </p:cNvPr>
          <p:cNvSpPr txBox="1"/>
          <p:nvPr/>
        </p:nvSpPr>
        <p:spPr>
          <a:xfrm>
            <a:off x="941291" y="4126154"/>
            <a:ext cx="10532714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2 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NF-kB nuclear translocation. Immunostaining of NF-kB (green), F-actin (phalloidin, magenta) and nucleus (Hoechst, blue), in control cells exposed to LPS (100 ng/ml) for 1 h. Representative confocal microscopy images of the negative control (by omitting NF-kB first antibody). Scale bar - 10 µm; magnification 40X.</a:t>
            </a:r>
            <a:endParaRPr lang="pt-PT" sz="12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CaixaDeTexto 3">
            <a:extLst>
              <a:ext uri="{FF2B5EF4-FFF2-40B4-BE49-F238E27FC236}">
                <a16:creationId xmlns:a16="http://schemas.microsoft.com/office/drawing/2014/main" id="{603F9256-F26D-643E-0E4C-1075C69EEC83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2 </a:t>
            </a:r>
            <a:endParaRPr lang="pt-PT" dirty="0"/>
          </a:p>
        </p:txBody>
      </p:sp>
      <p:pic>
        <p:nvPicPr>
          <p:cNvPr id="6" name="Imagem 5" descr="Uma imagem com captura de ecrã, roxo, alfazema, violeta&#10;&#10;Descrição gerada automaticamente">
            <a:extLst>
              <a:ext uri="{FF2B5EF4-FFF2-40B4-BE49-F238E27FC236}">
                <a16:creationId xmlns:a16="http://schemas.microsoft.com/office/drawing/2014/main" id="{DE1A2632-E6DD-0FD1-D5D2-F1499E8A5E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6504" y="690019"/>
            <a:ext cx="10262288" cy="3183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76038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8B479494-F8F6-7F3F-BE7E-E3884197A906}"/>
              </a:ext>
            </a:extLst>
          </p:cNvPr>
          <p:cNvSpPr txBox="1"/>
          <p:nvPr/>
        </p:nvSpPr>
        <p:spPr>
          <a:xfrm>
            <a:off x="1760276" y="5500721"/>
            <a:ext cx="8182252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usekeeping gene expression. RT-qPCR analysis of Hprt1 housekeeping gene expression in macrophages cultured in regular medium (Ctr) or LUSO NMW (B and S), not exposed or exposed to LPS (100 ng/ml) for 6 h and 18 h.</a:t>
            </a: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22E66E32-FCBC-1AA2-66A0-193E0587D35E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</a:t>
            </a:r>
            <a:r>
              <a:rPr lang="en-US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</a:t>
            </a:r>
            <a:endParaRPr lang="pt-PT" dirty="0"/>
          </a:p>
        </p:txBody>
      </p:sp>
      <p:pic>
        <p:nvPicPr>
          <p:cNvPr id="8" name="Imagem 7" descr="Uma imagem com texto, captura de ecrã, file, Tipo de letra&#10;&#10;Descrição gerada automaticamente">
            <a:extLst>
              <a:ext uri="{FF2B5EF4-FFF2-40B4-BE49-F238E27FC236}">
                <a16:creationId xmlns:a16="http://schemas.microsoft.com/office/drawing/2014/main" id="{1F09E5F3-18B8-19E0-7F82-4B252D1B8B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0276" y="1206192"/>
            <a:ext cx="7440493" cy="3942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49800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93736E72-1712-3EDC-84FB-A4B116482725}"/>
              </a:ext>
            </a:extLst>
          </p:cNvPr>
          <p:cNvSpPr txBox="1"/>
          <p:nvPr/>
        </p:nvSpPr>
        <p:spPr>
          <a:xfrm>
            <a:off x="689111" y="4860088"/>
            <a:ext cx="11714923" cy="3361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agocytic capacity assessed by flow cytometry. Representative dot plots of cell populations not exposed to fluorescent beads and used to gate positive internalization. </a:t>
            </a: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707C2D92-8765-A37D-F542-7ECDEE5B4F9D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4 </a:t>
            </a:r>
            <a:endParaRPr lang="pt-PT" dirty="0"/>
          </a:p>
        </p:txBody>
      </p:sp>
      <p:pic>
        <p:nvPicPr>
          <p:cNvPr id="8" name="Imagem 7" descr="Uma imagem com texto, diagrama, Gráfico, file&#10;&#10;Descrição gerada automaticamente">
            <a:extLst>
              <a:ext uri="{FF2B5EF4-FFF2-40B4-BE49-F238E27FC236}">
                <a16:creationId xmlns:a16="http://schemas.microsoft.com/office/drawing/2014/main" id="{D1B4BFD3-F0AC-45E7-F1D1-3677B6E057C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23" y="806652"/>
            <a:ext cx="10934782" cy="36841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89456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>
            <a:extLst>
              <a:ext uri="{FF2B5EF4-FFF2-40B4-BE49-F238E27FC236}">
                <a16:creationId xmlns:a16="http://schemas.microsoft.com/office/drawing/2014/main" id="{BB710946-E968-23F0-C462-FBC7D932B681}"/>
              </a:ext>
            </a:extLst>
          </p:cNvPr>
          <p:cNvSpPr txBox="1"/>
          <p:nvPr/>
        </p:nvSpPr>
        <p:spPr>
          <a:xfrm>
            <a:off x="2099466" y="5153606"/>
            <a:ext cx="8136835" cy="11671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k-Bα phosphorylation levels. 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) and total Ik-Bα protein levels in control cells exposed to LPS (100 ng/ml) for the time depicted in the figure, determined by WB. Representative blot images are presented (original, uncropped blots are presented in Fig. S5B, below). Data correspond to the mean ± SEM of four independent experiments. Statistics: One-way ANOVA with Tukey's multiple comparisons test. P&lt;0.05 was considered significant. * P&lt;0.05 and ** P&lt;0.01, compared to Ctr.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8DB79A37-E412-5B12-2099-278C2121EB0E}"/>
              </a:ext>
            </a:extLst>
          </p:cNvPr>
          <p:cNvSpPr txBox="1"/>
          <p:nvPr/>
        </p:nvSpPr>
        <p:spPr>
          <a:xfrm>
            <a:off x="152968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5 </a:t>
            </a:r>
            <a:r>
              <a:rPr lang="en-US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)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pt-PT" dirty="0"/>
          </a:p>
        </p:txBody>
      </p:sp>
      <p:pic>
        <p:nvPicPr>
          <p:cNvPr id="10" name="Imagem 9" descr="Uma imagem com texto, captura de ecrã, diagrama, Tipo de letra&#10;&#10;Descrição gerada automaticamente">
            <a:extLst>
              <a:ext uri="{FF2B5EF4-FFF2-40B4-BE49-F238E27FC236}">
                <a16:creationId xmlns:a16="http://schemas.microsoft.com/office/drawing/2014/main" id="{BEAE38FB-D737-9B6E-F998-5D41A398A7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9466" y="886405"/>
            <a:ext cx="7397224" cy="3818117"/>
          </a:xfrm>
          <a:prstGeom prst="rect">
            <a:avLst/>
          </a:prstGeom>
        </p:spPr>
      </p:pic>
      <p:sp>
        <p:nvSpPr>
          <p:cNvPr id="2" name="Retângulo 1">
            <a:extLst>
              <a:ext uri="{FF2B5EF4-FFF2-40B4-BE49-F238E27FC236}">
                <a16:creationId xmlns:a16="http://schemas.microsoft.com/office/drawing/2014/main" id="{F3D2F11C-2C9A-2231-1A5F-A638A7A46F73}"/>
              </a:ext>
            </a:extLst>
          </p:cNvPr>
          <p:cNvSpPr/>
          <p:nvPr/>
        </p:nvSpPr>
        <p:spPr>
          <a:xfrm>
            <a:off x="2353300" y="517073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260691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Número do Diapositivo 1">
            <a:extLst>
              <a:ext uri="{FF2B5EF4-FFF2-40B4-BE49-F238E27FC236}">
                <a16:creationId xmlns:a16="http://schemas.microsoft.com/office/drawing/2014/main" id="{594DFFA3-7732-147E-4365-7DE7F36CB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B2DD2-A115-48F4-A214-64C8D0FF5AEA}" type="slidenum">
              <a:rPr lang="pt-PT" smtClean="0"/>
              <a:t>7</a:t>
            </a:fld>
            <a:endParaRPr lang="pt-PT" dirty="0"/>
          </a:p>
        </p:txBody>
      </p:sp>
      <p:grpSp>
        <p:nvGrpSpPr>
          <p:cNvPr id="16" name="Agrupar 15">
            <a:extLst>
              <a:ext uri="{FF2B5EF4-FFF2-40B4-BE49-F238E27FC236}">
                <a16:creationId xmlns:a16="http://schemas.microsoft.com/office/drawing/2014/main" id="{EEF3E457-6FDB-BBCD-F745-C74D9BC71214}"/>
              </a:ext>
            </a:extLst>
          </p:cNvPr>
          <p:cNvGrpSpPr/>
          <p:nvPr/>
        </p:nvGrpSpPr>
        <p:grpSpPr>
          <a:xfrm>
            <a:off x="1720747" y="3710064"/>
            <a:ext cx="3772879" cy="2101335"/>
            <a:chOff x="7428565" y="1402315"/>
            <a:chExt cx="3772879" cy="2101335"/>
          </a:xfrm>
        </p:grpSpPr>
        <p:pic>
          <p:nvPicPr>
            <p:cNvPr id="4" name="Imagem 3" descr="Uma imagem com texto, Retângulo, envelope, captura de ecrã&#10;&#10;Descrição gerada automaticamente">
              <a:extLst>
                <a:ext uri="{FF2B5EF4-FFF2-40B4-BE49-F238E27FC236}">
                  <a16:creationId xmlns:a16="http://schemas.microsoft.com/office/drawing/2014/main" id="{0D3E9975-ACCE-15D7-5A51-B49F1410FC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176" r="15555" b="24324"/>
            <a:stretch/>
          </p:blipFill>
          <p:spPr>
            <a:xfrm>
              <a:off x="7428565" y="1402315"/>
              <a:ext cx="3197226" cy="210133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EB85DF9E-EDF5-59C5-B6DA-872F802F9D32}"/>
                </a:ext>
              </a:extLst>
            </p:cNvPr>
            <p:cNvSpPr txBox="1"/>
            <p:nvPr/>
          </p:nvSpPr>
          <p:spPr>
            <a:xfrm>
              <a:off x="7714700" y="2095083"/>
              <a:ext cx="348674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200" b="1" i="0" u="none" strike="noStrike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   2   3   4   5   6</a:t>
              </a:r>
              <a:endParaRPr lang="pt-PT" sz="1200" b="1" dirty="0"/>
            </a:p>
          </p:txBody>
        </p:sp>
      </p:grpSp>
      <p:sp>
        <p:nvSpPr>
          <p:cNvPr id="9" name="CaixaDeTexto 8">
            <a:extLst>
              <a:ext uri="{FF2B5EF4-FFF2-40B4-BE49-F238E27FC236}">
                <a16:creationId xmlns:a16="http://schemas.microsoft.com/office/drawing/2014/main" id="{B0C9E352-C1C7-BE07-9BA3-1A0813D266EC}"/>
              </a:ext>
            </a:extLst>
          </p:cNvPr>
          <p:cNvSpPr txBox="1"/>
          <p:nvPr/>
        </p:nvSpPr>
        <p:spPr>
          <a:xfrm>
            <a:off x="5385353" y="5299188"/>
            <a:ext cx="645049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200" i="0" u="sng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lang="pt-PT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1 – </a:t>
            </a:r>
            <a:r>
              <a:rPr lang="pt-PT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tr</a:t>
            </a:r>
            <a:r>
              <a:rPr lang="pt-PT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2 – LPS 10 min; 3 – LPS 20 min; 4 – L</a:t>
            </a:r>
            <a:r>
              <a:rPr lang="pt-PT" sz="120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S 30 min; 5 – LPS 60 min; 6 – LPS 360 min</a:t>
            </a:r>
            <a:endParaRPr lang="pt-P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" name="Agrupar 14">
            <a:extLst>
              <a:ext uri="{FF2B5EF4-FFF2-40B4-BE49-F238E27FC236}">
                <a16:creationId xmlns:a16="http://schemas.microsoft.com/office/drawing/2014/main" id="{0210DA7A-A4D4-98C5-7C36-88704903B9EE}"/>
              </a:ext>
            </a:extLst>
          </p:cNvPr>
          <p:cNvGrpSpPr/>
          <p:nvPr/>
        </p:nvGrpSpPr>
        <p:grpSpPr>
          <a:xfrm>
            <a:off x="7360455" y="1014467"/>
            <a:ext cx="3993345" cy="2100534"/>
            <a:chOff x="4030118" y="1470871"/>
            <a:chExt cx="3993345" cy="2100534"/>
          </a:xfrm>
        </p:grpSpPr>
        <p:pic>
          <p:nvPicPr>
            <p:cNvPr id="10" name="Imagem 9" descr="Uma imagem com branco, eletrodoméstico&#10;&#10;Descrição gerada automaticamente">
              <a:extLst>
                <a:ext uri="{FF2B5EF4-FFF2-40B4-BE49-F238E27FC236}">
                  <a16:creationId xmlns:a16="http://schemas.microsoft.com/office/drawing/2014/main" id="{E06EC78E-FAAF-7192-0A6F-FD8A1FA6D7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166" t="23268" r="15838" b="17283"/>
            <a:stretch/>
          </p:blipFill>
          <p:spPr>
            <a:xfrm>
              <a:off x="4030118" y="1470871"/>
              <a:ext cx="3371263" cy="21005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2324484A-EF1A-9BBA-86AD-DAB15E93EC4C}"/>
                </a:ext>
              </a:extLst>
            </p:cNvPr>
            <p:cNvSpPr txBox="1"/>
            <p:nvPr/>
          </p:nvSpPr>
          <p:spPr>
            <a:xfrm>
              <a:off x="4536719" y="2375744"/>
              <a:ext cx="348674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200" b="1" i="0" u="none" strike="noStrike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   2    3   4   5   6</a:t>
              </a:r>
              <a:endParaRPr lang="pt-PT" sz="1200" b="1" dirty="0"/>
            </a:p>
          </p:txBody>
        </p:sp>
      </p:grpSp>
      <p:grpSp>
        <p:nvGrpSpPr>
          <p:cNvPr id="14" name="Agrupar 13">
            <a:extLst>
              <a:ext uri="{FF2B5EF4-FFF2-40B4-BE49-F238E27FC236}">
                <a16:creationId xmlns:a16="http://schemas.microsoft.com/office/drawing/2014/main" id="{C1054CD8-C734-56A0-A5C0-A3E4CB6E45BD}"/>
              </a:ext>
            </a:extLst>
          </p:cNvPr>
          <p:cNvGrpSpPr/>
          <p:nvPr/>
        </p:nvGrpSpPr>
        <p:grpSpPr>
          <a:xfrm>
            <a:off x="1720747" y="956200"/>
            <a:ext cx="3910855" cy="2076563"/>
            <a:chOff x="609865" y="1475963"/>
            <a:chExt cx="3910855" cy="2076563"/>
          </a:xfrm>
        </p:grpSpPr>
        <p:pic>
          <p:nvPicPr>
            <p:cNvPr id="3" name="Imagem 2" descr="Uma imagem com texto, Retângulo, envelope, preto e branco&#10;&#10;Descrição gerada automaticamente">
              <a:extLst>
                <a:ext uri="{FF2B5EF4-FFF2-40B4-BE49-F238E27FC236}">
                  <a16:creationId xmlns:a16="http://schemas.microsoft.com/office/drawing/2014/main" id="{4C1C856D-529F-CD5F-9AA1-5E09F96C91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24332" r="12352" b="21679"/>
            <a:stretch/>
          </p:blipFill>
          <p:spPr>
            <a:xfrm>
              <a:off x="609865" y="1475963"/>
              <a:ext cx="3371263" cy="20765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6E21F636-F0C7-AB43-C44B-2868DFB9B5A8}"/>
                </a:ext>
              </a:extLst>
            </p:cNvPr>
            <p:cNvSpPr txBox="1"/>
            <p:nvPr/>
          </p:nvSpPr>
          <p:spPr>
            <a:xfrm>
              <a:off x="1033976" y="2607023"/>
              <a:ext cx="348674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pt-PT" sz="1200" b="1" i="0" u="none" strike="noStrike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   2   3   4   5   6</a:t>
              </a:r>
              <a:endParaRPr lang="pt-PT" sz="1200" b="1" dirty="0"/>
            </a:p>
          </p:txBody>
        </p:sp>
      </p:grpSp>
      <p:sp>
        <p:nvSpPr>
          <p:cNvPr id="17" name="Retângulo 16">
            <a:extLst>
              <a:ext uri="{FF2B5EF4-FFF2-40B4-BE49-F238E27FC236}">
                <a16:creationId xmlns:a16="http://schemas.microsoft.com/office/drawing/2014/main" id="{D0D85181-771C-F1DE-E161-BF8EED62F90D}"/>
              </a:ext>
            </a:extLst>
          </p:cNvPr>
          <p:cNvSpPr/>
          <p:nvPr/>
        </p:nvSpPr>
        <p:spPr>
          <a:xfrm>
            <a:off x="7874905" y="2178050"/>
            <a:ext cx="1214040" cy="1444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8" name="Retângulo 17">
            <a:extLst>
              <a:ext uri="{FF2B5EF4-FFF2-40B4-BE49-F238E27FC236}">
                <a16:creationId xmlns:a16="http://schemas.microsoft.com/office/drawing/2014/main" id="{5AB951E5-5D19-CB82-D7FD-6B5D8FA362A4}"/>
              </a:ext>
            </a:extLst>
          </p:cNvPr>
          <p:cNvSpPr/>
          <p:nvPr/>
        </p:nvSpPr>
        <p:spPr>
          <a:xfrm>
            <a:off x="2026627" y="4683638"/>
            <a:ext cx="1103971" cy="1434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19" name="Retângulo 18">
            <a:extLst>
              <a:ext uri="{FF2B5EF4-FFF2-40B4-BE49-F238E27FC236}">
                <a16:creationId xmlns:a16="http://schemas.microsoft.com/office/drawing/2014/main" id="{3E3CE8AF-50F8-8302-6423-876AA8F6C8C0}"/>
              </a:ext>
            </a:extLst>
          </p:cNvPr>
          <p:cNvSpPr/>
          <p:nvPr/>
        </p:nvSpPr>
        <p:spPr>
          <a:xfrm>
            <a:off x="2195005" y="2341596"/>
            <a:ext cx="1103971" cy="1434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38FE3678-1F98-A45B-9993-C557B3F4FC44}"/>
              </a:ext>
            </a:extLst>
          </p:cNvPr>
          <p:cNvSpPr txBox="1"/>
          <p:nvPr/>
        </p:nvSpPr>
        <p:spPr>
          <a:xfrm>
            <a:off x="1168542" y="1426948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pt-PT" sz="1200" b="1" dirty="0" err="1"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pt-PT" sz="1200" b="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5" name="Conexão reta 24">
            <a:extLst>
              <a:ext uri="{FF2B5EF4-FFF2-40B4-BE49-F238E27FC236}">
                <a16:creationId xmlns:a16="http://schemas.microsoft.com/office/drawing/2014/main" id="{502323DD-410E-EDFE-5889-41559ACEABC7}"/>
              </a:ext>
            </a:extLst>
          </p:cNvPr>
          <p:cNvCxnSpPr>
            <a:cxnSpLocks/>
          </p:cNvCxnSpPr>
          <p:nvPr/>
        </p:nvCxnSpPr>
        <p:spPr>
          <a:xfrm>
            <a:off x="1811445" y="1597027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A9EAB474-9220-9097-0E04-A3CF1C75A62D}"/>
              </a:ext>
            </a:extLst>
          </p:cNvPr>
          <p:cNvSpPr txBox="1"/>
          <p:nvPr/>
        </p:nvSpPr>
        <p:spPr>
          <a:xfrm>
            <a:off x="166117" y="9136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5B </a:t>
            </a:r>
            <a:endParaRPr lang="pt-PT" dirty="0"/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E9A6583E-CC83-1108-58DF-B383DE5B8E82}"/>
              </a:ext>
            </a:extLst>
          </p:cNvPr>
          <p:cNvSpPr txBox="1"/>
          <p:nvPr/>
        </p:nvSpPr>
        <p:spPr>
          <a:xfrm>
            <a:off x="1053770" y="4235904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>
                <a:ea typeface="Calibri" panose="020F0502020204030204" pitchFamily="34" charset="0"/>
                <a:cs typeface="Calibri" panose="020F0502020204030204" pitchFamily="34" charset="0"/>
              </a:rPr>
              <a:t>75 </a:t>
            </a:r>
            <a:r>
              <a:rPr lang="pt-PT" sz="1200" b="1" dirty="0" err="1"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pt-PT" sz="1200" b="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3" name="Conexão reta 32">
            <a:extLst>
              <a:ext uri="{FF2B5EF4-FFF2-40B4-BE49-F238E27FC236}">
                <a16:creationId xmlns:a16="http://schemas.microsoft.com/office/drawing/2014/main" id="{D14351FA-FBE6-4022-95F1-64E40196FB8D}"/>
              </a:ext>
            </a:extLst>
          </p:cNvPr>
          <p:cNvCxnSpPr>
            <a:cxnSpLocks/>
          </p:cNvCxnSpPr>
          <p:nvPr/>
        </p:nvCxnSpPr>
        <p:spPr>
          <a:xfrm>
            <a:off x="1696673" y="4396556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CaixaDeTexto 5">
            <a:extLst>
              <a:ext uri="{FF2B5EF4-FFF2-40B4-BE49-F238E27FC236}">
                <a16:creationId xmlns:a16="http://schemas.microsoft.com/office/drawing/2014/main" id="{BA830374-19A2-6230-588B-5E42FC33191B}"/>
              </a:ext>
            </a:extLst>
          </p:cNvPr>
          <p:cNvSpPr txBox="1"/>
          <p:nvPr/>
        </p:nvSpPr>
        <p:spPr>
          <a:xfrm>
            <a:off x="1086443" y="2175838"/>
            <a:ext cx="11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Ikb</a:t>
            </a:r>
            <a:r>
              <a:rPr lang="pt-PT" sz="1200" b="1" dirty="0"/>
              <a:t>-</a:t>
            </a:r>
            <a:r>
              <a:rPr lang="el-GR" sz="1200" b="1" dirty="0">
                <a:cs typeface="Times New Roman" panose="02020603050405020304" pitchFamily="18" charset="0"/>
              </a:rPr>
              <a:t>α</a:t>
            </a:r>
            <a:r>
              <a:rPr lang="pt-PT" sz="1200" b="1" dirty="0">
                <a:cs typeface="Times New Roman" panose="02020603050405020304" pitchFamily="18" charset="0"/>
              </a:rPr>
              <a:t> (39 </a:t>
            </a:r>
            <a:r>
              <a:rPr lang="pt-PT" sz="1200" b="1" dirty="0" err="1">
                <a:cs typeface="Times New Roman" panose="02020603050405020304" pitchFamily="18" charset="0"/>
              </a:rPr>
              <a:t>kDa</a:t>
            </a:r>
            <a:r>
              <a:rPr lang="pt-PT" sz="1200" b="1" dirty="0">
                <a:cs typeface="Times New Roman" panose="02020603050405020304" pitchFamily="18" charset="0"/>
              </a:rPr>
              <a:t>)</a:t>
            </a:r>
            <a:endParaRPr lang="pt-PT" sz="1200" b="1" dirty="0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F5B73A6D-3A8E-4121-17FC-47050FCBD7DB}"/>
              </a:ext>
            </a:extLst>
          </p:cNvPr>
          <p:cNvSpPr txBox="1"/>
          <p:nvPr/>
        </p:nvSpPr>
        <p:spPr>
          <a:xfrm>
            <a:off x="700950" y="4633261"/>
            <a:ext cx="1296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Tubulin</a:t>
            </a:r>
            <a:r>
              <a:rPr lang="pt-PT" sz="1200" b="1" dirty="0"/>
              <a:t> (50 </a:t>
            </a:r>
            <a:r>
              <a:rPr lang="pt-PT" sz="1200" b="1" dirty="0" err="1"/>
              <a:t>kDa</a:t>
            </a:r>
            <a:r>
              <a:rPr lang="pt-PT" sz="1200" b="1" dirty="0"/>
              <a:t>)</a:t>
            </a:r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6BD33BCC-D210-F141-DBE8-B094D2B25942}"/>
              </a:ext>
            </a:extLst>
          </p:cNvPr>
          <p:cNvSpPr txBox="1"/>
          <p:nvPr/>
        </p:nvSpPr>
        <p:spPr>
          <a:xfrm>
            <a:off x="6083912" y="2115541"/>
            <a:ext cx="1806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Phospho-Ikb</a:t>
            </a:r>
            <a:r>
              <a:rPr lang="pt-PT" sz="1200" b="1" dirty="0"/>
              <a:t>-</a:t>
            </a:r>
            <a:r>
              <a:rPr lang="el-GR" sz="1200" b="1" dirty="0">
                <a:cs typeface="Times New Roman" panose="02020603050405020304" pitchFamily="18" charset="0"/>
              </a:rPr>
              <a:t>α</a:t>
            </a:r>
            <a:r>
              <a:rPr lang="pt-PT" sz="1200" b="1" dirty="0">
                <a:cs typeface="Times New Roman" panose="02020603050405020304" pitchFamily="18" charset="0"/>
              </a:rPr>
              <a:t> (39 </a:t>
            </a:r>
            <a:r>
              <a:rPr lang="pt-PT" sz="1200" b="1" dirty="0" err="1">
                <a:cs typeface="Times New Roman" panose="02020603050405020304" pitchFamily="18" charset="0"/>
              </a:rPr>
              <a:t>kDa</a:t>
            </a:r>
            <a:r>
              <a:rPr lang="pt-PT" sz="1200" b="1" dirty="0">
                <a:cs typeface="Times New Roman" panose="02020603050405020304" pitchFamily="18" charset="0"/>
              </a:rPr>
              <a:t>)</a:t>
            </a:r>
            <a:endParaRPr lang="pt-PT" sz="1200" b="1" dirty="0"/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87A42F7E-DEDA-E4B8-A9B4-8C816AD5EBF3}"/>
              </a:ext>
            </a:extLst>
          </p:cNvPr>
          <p:cNvSpPr txBox="1"/>
          <p:nvPr/>
        </p:nvSpPr>
        <p:spPr>
          <a:xfrm>
            <a:off x="1188964" y="1711326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>
                <a:ea typeface="Calibri" panose="020F0502020204030204" pitchFamily="34" charset="0"/>
                <a:cs typeface="Calibri" panose="020F0502020204030204" pitchFamily="34" charset="0"/>
              </a:rPr>
              <a:t>63 </a:t>
            </a:r>
            <a:r>
              <a:rPr lang="pt-PT" sz="1200" b="1" dirty="0" err="1"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pt-PT" sz="1200" b="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6" name="Conexão reta 35">
            <a:extLst>
              <a:ext uri="{FF2B5EF4-FFF2-40B4-BE49-F238E27FC236}">
                <a16:creationId xmlns:a16="http://schemas.microsoft.com/office/drawing/2014/main" id="{15268E20-C8AC-D4D0-C887-E8B072CF2152}"/>
              </a:ext>
            </a:extLst>
          </p:cNvPr>
          <p:cNvCxnSpPr>
            <a:cxnSpLocks/>
          </p:cNvCxnSpPr>
          <p:nvPr/>
        </p:nvCxnSpPr>
        <p:spPr>
          <a:xfrm>
            <a:off x="1813015" y="1862550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934B909E-04FB-0467-1780-B232794B1C3F}"/>
              </a:ext>
            </a:extLst>
          </p:cNvPr>
          <p:cNvSpPr txBox="1"/>
          <p:nvPr/>
        </p:nvSpPr>
        <p:spPr>
          <a:xfrm>
            <a:off x="6627348" y="1668868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>
                <a:ea typeface="Calibri" panose="020F0502020204030204" pitchFamily="34" charset="0"/>
                <a:cs typeface="Calibri" panose="020F0502020204030204" pitchFamily="34" charset="0"/>
              </a:rPr>
              <a:t>63 </a:t>
            </a:r>
            <a:r>
              <a:rPr lang="pt-PT" sz="1200" b="1" dirty="0" err="1"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pt-PT" sz="1200" b="1" dirty="0"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8" name="Conexão reta 37">
            <a:extLst>
              <a:ext uri="{FF2B5EF4-FFF2-40B4-BE49-F238E27FC236}">
                <a16:creationId xmlns:a16="http://schemas.microsoft.com/office/drawing/2014/main" id="{F9C32956-C3EE-6AEE-E150-47A5E05AC0E4}"/>
              </a:ext>
            </a:extLst>
          </p:cNvPr>
          <p:cNvCxnSpPr>
            <a:cxnSpLocks/>
          </p:cNvCxnSpPr>
          <p:nvPr/>
        </p:nvCxnSpPr>
        <p:spPr>
          <a:xfrm>
            <a:off x="7251399" y="1820092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9" name="Imagem 38">
            <a:extLst>
              <a:ext uri="{FF2B5EF4-FFF2-40B4-BE49-F238E27FC236}">
                <a16:creationId xmlns:a16="http://schemas.microsoft.com/office/drawing/2014/main" id="{32C5CED6-C262-9F9E-D0A6-E9A5429C290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92" r="68979"/>
          <a:stretch/>
        </p:blipFill>
        <p:spPr>
          <a:xfrm>
            <a:off x="373084" y="893746"/>
            <a:ext cx="655731" cy="2051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45258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>
            <a:extLst>
              <a:ext uri="{FF2B5EF4-FFF2-40B4-BE49-F238E27FC236}">
                <a16:creationId xmlns:a16="http://schemas.microsoft.com/office/drawing/2014/main" id="{FAE2AC92-93A4-934C-F8C3-81D0196EF430}"/>
              </a:ext>
            </a:extLst>
          </p:cNvPr>
          <p:cNvSpPr txBox="1"/>
          <p:nvPr/>
        </p:nvSpPr>
        <p:spPr>
          <a:xfrm>
            <a:off x="3256006" y="5068899"/>
            <a:ext cx="7834865" cy="1721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6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ro-inflammatory protein levels.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 – B) Protein levels of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NO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pro-IL-1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β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determined by WB and (C – E) IL-6, IL-1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β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TNF-</a:t>
            </a:r>
            <a:r>
              <a:rPr kumimoji="0" lang="el-G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α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secretion levels determined by ELISA, in control cells incubated with Indomethacin (Indo, 10 µg/ml), without or with LPS (100 ng/ml) for 24 h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riginal blots representative of the data depicted in A and B are presented in Fig. S6F, below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ata corresponds to the mean ± SEM of two-three independent experiments. Statistics: One-way ANOVA with Tukey's multiple comparisons test and unpaired t-test (t). P&lt;0.05 was considered significant.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nd * P&lt;0.05, ** P&lt;0.01, *** P&lt;0.001 and **** P&lt;0.0001. Symbols above bars without the connection line, represent comparison with Ctr. 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9319B15E-C6CB-E35D-61E9-660563702566}"/>
              </a:ext>
            </a:extLst>
          </p:cNvPr>
          <p:cNvSpPr txBox="1"/>
          <p:nvPr/>
        </p:nvSpPr>
        <p:spPr>
          <a:xfrm>
            <a:off x="0" y="6798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6 (A-E) </a:t>
            </a:r>
            <a:endParaRPr lang="pt-PT" dirty="0"/>
          </a:p>
        </p:txBody>
      </p:sp>
      <p:pic>
        <p:nvPicPr>
          <p:cNvPr id="10" name="Imagem 9" descr="Uma imagem com texto, diagrama, Desenho técnico, Esquema&#10;&#10;Descrição gerada automaticamente">
            <a:extLst>
              <a:ext uri="{FF2B5EF4-FFF2-40B4-BE49-F238E27FC236}">
                <a16:creationId xmlns:a16="http://schemas.microsoft.com/office/drawing/2014/main" id="{6BB442F7-1B90-E1A2-CA18-1E7BC644DE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3493" y="104958"/>
            <a:ext cx="7334587" cy="5103146"/>
          </a:xfrm>
          <a:prstGeom prst="rect">
            <a:avLst/>
          </a:prstGeom>
        </p:spPr>
      </p:pic>
      <p:sp>
        <p:nvSpPr>
          <p:cNvPr id="2" name="Retângulo 1">
            <a:extLst>
              <a:ext uri="{FF2B5EF4-FFF2-40B4-BE49-F238E27FC236}">
                <a16:creationId xmlns:a16="http://schemas.microsoft.com/office/drawing/2014/main" id="{503673C7-8718-5A92-5958-4B0AF1ED0C0A}"/>
              </a:ext>
            </a:extLst>
          </p:cNvPr>
          <p:cNvSpPr/>
          <p:nvPr/>
        </p:nvSpPr>
        <p:spPr>
          <a:xfrm>
            <a:off x="3214539" y="0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Retângulo 2">
            <a:extLst>
              <a:ext uri="{FF2B5EF4-FFF2-40B4-BE49-F238E27FC236}">
                <a16:creationId xmlns:a16="http://schemas.microsoft.com/office/drawing/2014/main" id="{7702B1CE-C186-B9D9-0915-30CD5F22D2F9}"/>
              </a:ext>
            </a:extLst>
          </p:cNvPr>
          <p:cNvSpPr/>
          <p:nvPr/>
        </p:nvSpPr>
        <p:spPr>
          <a:xfrm>
            <a:off x="5661585" y="0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Retângulo 3">
            <a:extLst>
              <a:ext uri="{FF2B5EF4-FFF2-40B4-BE49-F238E27FC236}">
                <a16:creationId xmlns:a16="http://schemas.microsoft.com/office/drawing/2014/main" id="{DE85F7C6-E64C-04CB-897E-6F3A5AC5BE65}"/>
              </a:ext>
            </a:extLst>
          </p:cNvPr>
          <p:cNvSpPr/>
          <p:nvPr/>
        </p:nvSpPr>
        <p:spPr>
          <a:xfrm>
            <a:off x="3214539" y="250045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Retângulo 4">
            <a:extLst>
              <a:ext uri="{FF2B5EF4-FFF2-40B4-BE49-F238E27FC236}">
                <a16:creationId xmlns:a16="http://schemas.microsoft.com/office/drawing/2014/main" id="{EC2A2A2E-9079-5EC1-05AB-FBAF73E48F48}"/>
              </a:ext>
            </a:extLst>
          </p:cNvPr>
          <p:cNvSpPr/>
          <p:nvPr/>
        </p:nvSpPr>
        <p:spPr>
          <a:xfrm>
            <a:off x="5661585" y="250045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A975E6D8-8C52-FE8C-1245-1CE8C776CA6C}"/>
              </a:ext>
            </a:extLst>
          </p:cNvPr>
          <p:cNvSpPr/>
          <p:nvPr/>
        </p:nvSpPr>
        <p:spPr>
          <a:xfrm>
            <a:off x="8108631" y="2500455"/>
            <a:ext cx="423747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PT" sz="1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42048051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Número do Diapositivo 1">
            <a:extLst>
              <a:ext uri="{FF2B5EF4-FFF2-40B4-BE49-F238E27FC236}">
                <a16:creationId xmlns:a16="http://schemas.microsoft.com/office/drawing/2014/main" id="{CF728F5F-76A7-B576-7AC5-4A04DBB7C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B2DD2-A115-48F4-A214-64C8D0FF5AEA}" type="slidenum">
              <a:rPr lang="pt-PT" smtClean="0"/>
              <a:t>9</a:t>
            </a:fld>
            <a:endParaRPr lang="pt-PT"/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24CB5B7B-2178-3852-740B-4793692075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63" t="16130" r="57897" b="22444"/>
          <a:stretch/>
        </p:blipFill>
        <p:spPr>
          <a:xfrm>
            <a:off x="1802292" y="586432"/>
            <a:ext cx="3669710" cy="2642653"/>
          </a:xfrm>
          <a:prstGeom prst="rect">
            <a:avLst/>
          </a:prstGeom>
        </p:spPr>
      </p:pic>
      <p:pic>
        <p:nvPicPr>
          <p:cNvPr id="13" name="Imagem 12">
            <a:extLst>
              <a:ext uri="{FF2B5EF4-FFF2-40B4-BE49-F238E27FC236}">
                <a16:creationId xmlns:a16="http://schemas.microsoft.com/office/drawing/2014/main" id="{507EB174-D276-7ACB-5C3C-630DA09681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25" t="21164" r="61241" b="21567"/>
          <a:stretch/>
        </p:blipFill>
        <p:spPr>
          <a:xfrm>
            <a:off x="7611448" y="608636"/>
            <a:ext cx="3669710" cy="2642653"/>
          </a:xfrm>
          <a:prstGeom prst="rect">
            <a:avLst/>
          </a:prstGeom>
        </p:spPr>
      </p:pic>
      <p:pic>
        <p:nvPicPr>
          <p:cNvPr id="21" name="Imagem 20">
            <a:extLst>
              <a:ext uri="{FF2B5EF4-FFF2-40B4-BE49-F238E27FC236}">
                <a16:creationId xmlns:a16="http://schemas.microsoft.com/office/drawing/2014/main" id="{7DD3B968-1001-4912-5A24-67D47DD48F7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70" t="21626" r="55744" b="22833"/>
          <a:stretch/>
        </p:blipFill>
        <p:spPr>
          <a:xfrm>
            <a:off x="7619672" y="3416299"/>
            <a:ext cx="3676401" cy="2545997"/>
          </a:xfrm>
          <a:prstGeom prst="rect">
            <a:avLst/>
          </a:prstGeom>
        </p:spPr>
      </p:pic>
      <p:pic>
        <p:nvPicPr>
          <p:cNvPr id="25" name="Imagem 24">
            <a:extLst>
              <a:ext uri="{FF2B5EF4-FFF2-40B4-BE49-F238E27FC236}">
                <a16:creationId xmlns:a16="http://schemas.microsoft.com/office/drawing/2014/main" id="{886494AD-1CFB-19DA-B47B-AA04FA64414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311" t="16323" r="57281" b="23642"/>
          <a:stretch/>
        </p:blipFill>
        <p:spPr>
          <a:xfrm>
            <a:off x="1864206" y="3403322"/>
            <a:ext cx="3568255" cy="2551272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7B136241-D756-D3D2-C281-4B33F57A1E83}"/>
              </a:ext>
            </a:extLst>
          </p:cNvPr>
          <p:cNvSpPr txBox="1"/>
          <p:nvPr/>
        </p:nvSpPr>
        <p:spPr>
          <a:xfrm>
            <a:off x="193551" y="2873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. S</a:t>
            </a:r>
            <a:r>
              <a:rPr lang="en-US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6F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pt-PT" dirty="0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286B7AF6-4759-8C0A-A736-7354A7E18556}"/>
              </a:ext>
            </a:extLst>
          </p:cNvPr>
          <p:cNvSpPr txBox="1"/>
          <p:nvPr/>
        </p:nvSpPr>
        <p:spPr>
          <a:xfrm>
            <a:off x="982402" y="1007528"/>
            <a:ext cx="1261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iNOS</a:t>
            </a:r>
            <a:r>
              <a:rPr lang="pt-PT" sz="1200" b="1" dirty="0"/>
              <a:t> (131 </a:t>
            </a:r>
            <a:r>
              <a:rPr lang="pt-PT" sz="1200" b="1" dirty="0" err="1"/>
              <a:t>kDa</a:t>
            </a:r>
            <a:r>
              <a:rPr lang="pt-PT" sz="1200" b="1" dirty="0"/>
              <a:t>)</a:t>
            </a:r>
          </a:p>
        </p:txBody>
      </p:sp>
      <p:sp>
        <p:nvSpPr>
          <p:cNvPr id="6" name="Retângulo 5">
            <a:extLst>
              <a:ext uri="{FF2B5EF4-FFF2-40B4-BE49-F238E27FC236}">
                <a16:creationId xmlns:a16="http://schemas.microsoft.com/office/drawing/2014/main" id="{9CDB7C44-3A4B-D9A6-1615-D596C9FD2EF1}"/>
              </a:ext>
            </a:extLst>
          </p:cNvPr>
          <p:cNvSpPr/>
          <p:nvPr/>
        </p:nvSpPr>
        <p:spPr>
          <a:xfrm>
            <a:off x="3524557" y="1085959"/>
            <a:ext cx="447664" cy="1856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031EA764-A9A7-4D64-9A84-11D207CA392A}"/>
              </a:ext>
            </a:extLst>
          </p:cNvPr>
          <p:cNvSpPr txBox="1"/>
          <p:nvPr/>
        </p:nvSpPr>
        <p:spPr>
          <a:xfrm rot="19713171">
            <a:off x="2215931" y="761178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Ctr</a:t>
            </a:r>
            <a:endParaRPr lang="pt-PT" dirty="0"/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AFC60CD3-0DA5-4329-4CA6-9A8A297278DA}"/>
              </a:ext>
            </a:extLst>
          </p:cNvPr>
          <p:cNvSpPr txBox="1"/>
          <p:nvPr/>
        </p:nvSpPr>
        <p:spPr>
          <a:xfrm rot="19713171">
            <a:off x="2800921" y="760860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LPS</a:t>
            </a:r>
            <a:endParaRPr lang="pt-PT" dirty="0"/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6E5F15A7-002D-ACB8-A577-BEE1534A9C62}"/>
              </a:ext>
            </a:extLst>
          </p:cNvPr>
          <p:cNvSpPr txBox="1"/>
          <p:nvPr/>
        </p:nvSpPr>
        <p:spPr>
          <a:xfrm rot="19713171">
            <a:off x="3423915" y="551323"/>
            <a:ext cx="1263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</a:t>
            </a:r>
            <a:endParaRPr lang="pt-PT" dirty="0"/>
          </a:p>
        </p:txBody>
      </p:sp>
      <p:sp>
        <p:nvSpPr>
          <p:cNvPr id="37" name="Retângulo 36">
            <a:extLst>
              <a:ext uri="{FF2B5EF4-FFF2-40B4-BE49-F238E27FC236}">
                <a16:creationId xmlns:a16="http://schemas.microsoft.com/office/drawing/2014/main" id="{D22740C7-2969-2F11-6A61-004D6EC8F361}"/>
              </a:ext>
            </a:extLst>
          </p:cNvPr>
          <p:cNvSpPr/>
          <p:nvPr/>
        </p:nvSpPr>
        <p:spPr>
          <a:xfrm>
            <a:off x="2290300" y="1078758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8" name="Retângulo 37">
            <a:extLst>
              <a:ext uri="{FF2B5EF4-FFF2-40B4-BE49-F238E27FC236}">
                <a16:creationId xmlns:a16="http://schemas.microsoft.com/office/drawing/2014/main" id="{E9C70141-3A2E-2248-A18D-A9988035F69D}"/>
              </a:ext>
            </a:extLst>
          </p:cNvPr>
          <p:cNvSpPr/>
          <p:nvPr/>
        </p:nvSpPr>
        <p:spPr>
          <a:xfrm>
            <a:off x="2867472" y="1078758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C811FD3C-CF10-36B8-8B8D-5E76C968AD36}"/>
              </a:ext>
            </a:extLst>
          </p:cNvPr>
          <p:cNvSpPr txBox="1"/>
          <p:nvPr/>
        </p:nvSpPr>
        <p:spPr>
          <a:xfrm rot="19713171">
            <a:off x="3616303" y="523378"/>
            <a:ext cx="15147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+LPS</a:t>
            </a:r>
            <a:endParaRPr lang="pt-PT" dirty="0"/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300F0E1E-BA2D-5ECF-8DF7-B19FAE28D218}"/>
              </a:ext>
            </a:extLst>
          </p:cNvPr>
          <p:cNvSpPr txBox="1"/>
          <p:nvPr/>
        </p:nvSpPr>
        <p:spPr>
          <a:xfrm>
            <a:off x="1241913" y="1265170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/>
              <a:t>75 </a:t>
            </a:r>
            <a:r>
              <a:rPr lang="pt-PT" sz="1200" b="1" dirty="0" err="1"/>
              <a:t>kDa</a:t>
            </a:r>
            <a:endParaRPr lang="pt-PT" sz="1200" b="1" dirty="0"/>
          </a:p>
        </p:txBody>
      </p:sp>
      <p:cxnSp>
        <p:nvCxnSpPr>
          <p:cNvPr id="41" name="Conexão reta 40">
            <a:extLst>
              <a:ext uri="{FF2B5EF4-FFF2-40B4-BE49-F238E27FC236}">
                <a16:creationId xmlns:a16="http://schemas.microsoft.com/office/drawing/2014/main" id="{BDF655D8-2778-F3F7-1BEC-4342330526AD}"/>
              </a:ext>
            </a:extLst>
          </p:cNvPr>
          <p:cNvCxnSpPr>
            <a:cxnSpLocks/>
          </p:cNvCxnSpPr>
          <p:nvPr/>
        </p:nvCxnSpPr>
        <p:spPr>
          <a:xfrm>
            <a:off x="1892919" y="1403670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CaixaDeTexto 43">
            <a:extLst>
              <a:ext uri="{FF2B5EF4-FFF2-40B4-BE49-F238E27FC236}">
                <a16:creationId xmlns:a16="http://schemas.microsoft.com/office/drawing/2014/main" id="{EDF8B31A-FD49-2075-9909-0FCE8A33DA9B}"/>
              </a:ext>
            </a:extLst>
          </p:cNvPr>
          <p:cNvSpPr txBox="1"/>
          <p:nvPr/>
        </p:nvSpPr>
        <p:spPr>
          <a:xfrm>
            <a:off x="6269559" y="1898249"/>
            <a:ext cx="13978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/>
              <a:t>Pro-IL-1</a:t>
            </a:r>
            <a:r>
              <a:rPr lang="pt-PT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pt-PT" sz="1200" b="1" dirty="0"/>
              <a:t> (35 </a:t>
            </a:r>
            <a:r>
              <a:rPr lang="pt-PT" sz="1200" b="1" dirty="0" err="1"/>
              <a:t>kDa</a:t>
            </a:r>
            <a:r>
              <a:rPr lang="pt-PT" sz="1200" b="1" dirty="0"/>
              <a:t>)</a:t>
            </a:r>
          </a:p>
        </p:txBody>
      </p:sp>
      <p:sp>
        <p:nvSpPr>
          <p:cNvPr id="45" name="Retângulo 44">
            <a:extLst>
              <a:ext uri="{FF2B5EF4-FFF2-40B4-BE49-F238E27FC236}">
                <a16:creationId xmlns:a16="http://schemas.microsoft.com/office/drawing/2014/main" id="{C12A68B8-2077-0A17-05BA-EACD3117D2EE}"/>
              </a:ext>
            </a:extLst>
          </p:cNvPr>
          <p:cNvSpPr/>
          <p:nvPr/>
        </p:nvSpPr>
        <p:spPr>
          <a:xfrm>
            <a:off x="9142690" y="1954745"/>
            <a:ext cx="447664" cy="1856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46" name="CaixaDeTexto 45">
            <a:extLst>
              <a:ext uri="{FF2B5EF4-FFF2-40B4-BE49-F238E27FC236}">
                <a16:creationId xmlns:a16="http://schemas.microsoft.com/office/drawing/2014/main" id="{DA63449A-D91B-BD11-0AC1-0FAE0905FED5}"/>
              </a:ext>
            </a:extLst>
          </p:cNvPr>
          <p:cNvSpPr txBox="1"/>
          <p:nvPr/>
        </p:nvSpPr>
        <p:spPr>
          <a:xfrm rot="19713171">
            <a:off x="7606653" y="1614062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Ctr</a:t>
            </a:r>
            <a:endParaRPr lang="pt-PT" dirty="0"/>
          </a:p>
        </p:txBody>
      </p:sp>
      <p:sp>
        <p:nvSpPr>
          <p:cNvPr id="47" name="CaixaDeTexto 46">
            <a:extLst>
              <a:ext uri="{FF2B5EF4-FFF2-40B4-BE49-F238E27FC236}">
                <a16:creationId xmlns:a16="http://schemas.microsoft.com/office/drawing/2014/main" id="{19A3FF6A-C686-FD92-72F3-D2396FE0CC37}"/>
              </a:ext>
            </a:extLst>
          </p:cNvPr>
          <p:cNvSpPr txBox="1"/>
          <p:nvPr/>
        </p:nvSpPr>
        <p:spPr>
          <a:xfrm rot="19713171">
            <a:off x="8334766" y="1597842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LPS</a:t>
            </a:r>
            <a:endParaRPr lang="pt-PT" dirty="0"/>
          </a:p>
        </p:txBody>
      </p:sp>
      <p:sp>
        <p:nvSpPr>
          <p:cNvPr id="48" name="Retângulo 47">
            <a:extLst>
              <a:ext uri="{FF2B5EF4-FFF2-40B4-BE49-F238E27FC236}">
                <a16:creationId xmlns:a16="http://schemas.microsoft.com/office/drawing/2014/main" id="{1C6C5C41-5F3F-E311-1C34-4180E979F3F2}"/>
              </a:ext>
            </a:extLst>
          </p:cNvPr>
          <p:cNvSpPr/>
          <p:nvPr/>
        </p:nvSpPr>
        <p:spPr>
          <a:xfrm>
            <a:off x="7681022" y="1929256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49" name="Retângulo 48">
            <a:extLst>
              <a:ext uri="{FF2B5EF4-FFF2-40B4-BE49-F238E27FC236}">
                <a16:creationId xmlns:a16="http://schemas.microsoft.com/office/drawing/2014/main" id="{D902A1DB-C064-D82F-5E85-527951EB2213}"/>
              </a:ext>
            </a:extLst>
          </p:cNvPr>
          <p:cNvSpPr/>
          <p:nvPr/>
        </p:nvSpPr>
        <p:spPr>
          <a:xfrm>
            <a:off x="8387796" y="1912161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52" name="CaixaDeTexto 51">
            <a:extLst>
              <a:ext uri="{FF2B5EF4-FFF2-40B4-BE49-F238E27FC236}">
                <a16:creationId xmlns:a16="http://schemas.microsoft.com/office/drawing/2014/main" id="{AE7A1598-C7C8-D404-42E3-E9AA89C166D2}"/>
              </a:ext>
            </a:extLst>
          </p:cNvPr>
          <p:cNvSpPr txBox="1"/>
          <p:nvPr/>
        </p:nvSpPr>
        <p:spPr>
          <a:xfrm rot="19713171">
            <a:off x="8988691" y="1444593"/>
            <a:ext cx="1263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</a:t>
            </a:r>
            <a:endParaRPr lang="pt-PT" dirty="0"/>
          </a:p>
        </p:txBody>
      </p:sp>
      <p:sp>
        <p:nvSpPr>
          <p:cNvPr id="53" name="CaixaDeTexto 52">
            <a:extLst>
              <a:ext uri="{FF2B5EF4-FFF2-40B4-BE49-F238E27FC236}">
                <a16:creationId xmlns:a16="http://schemas.microsoft.com/office/drawing/2014/main" id="{0895E8FF-218D-50F0-85A0-8B24E26A273C}"/>
              </a:ext>
            </a:extLst>
          </p:cNvPr>
          <p:cNvSpPr txBox="1"/>
          <p:nvPr/>
        </p:nvSpPr>
        <p:spPr>
          <a:xfrm rot="19713171">
            <a:off x="9268540" y="1368942"/>
            <a:ext cx="15147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+LPS</a:t>
            </a:r>
            <a:endParaRPr lang="pt-PT" dirty="0"/>
          </a:p>
        </p:txBody>
      </p:sp>
      <p:sp>
        <p:nvSpPr>
          <p:cNvPr id="54" name="CaixaDeTexto 53">
            <a:extLst>
              <a:ext uri="{FF2B5EF4-FFF2-40B4-BE49-F238E27FC236}">
                <a16:creationId xmlns:a16="http://schemas.microsoft.com/office/drawing/2014/main" id="{0DFAD89C-58E6-5BBE-CFEC-8D813D63E9F8}"/>
              </a:ext>
            </a:extLst>
          </p:cNvPr>
          <p:cNvSpPr txBox="1"/>
          <p:nvPr/>
        </p:nvSpPr>
        <p:spPr>
          <a:xfrm>
            <a:off x="863255" y="4457887"/>
            <a:ext cx="1296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Tubulin</a:t>
            </a:r>
            <a:r>
              <a:rPr lang="pt-PT" sz="1200" b="1" dirty="0"/>
              <a:t> (50 </a:t>
            </a:r>
            <a:r>
              <a:rPr lang="pt-PT" sz="1200" b="1" dirty="0" err="1"/>
              <a:t>kDa</a:t>
            </a:r>
            <a:r>
              <a:rPr lang="pt-PT" sz="1200" b="1" dirty="0"/>
              <a:t>)</a:t>
            </a:r>
          </a:p>
        </p:txBody>
      </p:sp>
      <p:sp>
        <p:nvSpPr>
          <p:cNvPr id="55" name="Retângulo 54">
            <a:extLst>
              <a:ext uri="{FF2B5EF4-FFF2-40B4-BE49-F238E27FC236}">
                <a16:creationId xmlns:a16="http://schemas.microsoft.com/office/drawing/2014/main" id="{C78CC0F6-DF0F-88BC-FD4A-50C5807BAB05}"/>
              </a:ext>
            </a:extLst>
          </p:cNvPr>
          <p:cNvSpPr/>
          <p:nvPr/>
        </p:nvSpPr>
        <p:spPr>
          <a:xfrm>
            <a:off x="3445630" y="4520758"/>
            <a:ext cx="447664" cy="1856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E936C295-E467-2C01-A54B-6BEB08AF003B}"/>
              </a:ext>
            </a:extLst>
          </p:cNvPr>
          <p:cNvSpPr txBox="1"/>
          <p:nvPr/>
        </p:nvSpPr>
        <p:spPr>
          <a:xfrm rot="19713171">
            <a:off x="2145748" y="4195977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Ctr</a:t>
            </a:r>
            <a:endParaRPr lang="pt-PT" dirty="0"/>
          </a:p>
        </p:txBody>
      </p:sp>
      <p:sp>
        <p:nvSpPr>
          <p:cNvPr id="57" name="CaixaDeTexto 56">
            <a:extLst>
              <a:ext uri="{FF2B5EF4-FFF2-40B4-BE49-F238E27FC236}">
                <a16:creationId xmlns:a16="http://schemas.microsoft.com/office/drawing/2014/main" id="{6B2B3A8F-31B4-947D-134B-E98DA363CCC8}"/>
              </a:ext>
            </a:extLst>
          </p:cNvPr>
          <p:cNvSpPr txBox="1"/>
          <p:nvPr/>
        </p:nvSpPr>
        <p:spPr>
          <a:xfrm rot="19713171">
            <a:off x="2764302" y="4176811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LPS</a:t>
            </a:r>
            <a:endParaRPr lang="pt-PT" dirty="0"/>
          </a:p>
        </p:txBody>
      </p:sp>
      <p:sp>
        <p:nvSpPr>
          <p:cNvPr id="58" name="CaixaDeTexto 57">
            <a:extLst>
              <a:ext uri="{FF2B5EF4-FFF2-40B4-BE49-F238E27FC236}">
                <a16:creationId xmlns:a16="http://schemas.microsoft.com/office/drawing/2014/main" id="{8FC22434-A4BD-CC4B-E195-6F22AC00D95A}"/>
              </a:ext>
            </a:extLst>
          </p:cNvPr>
          <p:cNvSpPr txBox="1"/>
          <p:nvPr/>
        </p:nvSpPr>
        <p:spPr>
          <a:xfrm rot="19713171">
            <a:off x="3331472" y="3986122"/>
            <a:ext cx="1263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</a:t>
            </a:r>
            <a:endParaRPr lang="pt-PT" dirty="0"/>
          </a:p>
        </p:txBody>
      </p:sp>
      <p:sp>
        <p:nvSpPr>
          <p:cNvPr id="59" name="Retângulo 58">
            <a:extLst>
              <a:ext uri="{FF2B5EF4-FFF2-40B4-BE49-F238E27FC236}">
                <a16:creationId xmlns:a16="http://schemas.microsoft.com/office/drawing/2014/main" id="{D1AABBAA-0DFF-FAC3-A037-5F70F77AB29F}"/>
              </a:ext>
            </a:extLst>
          </p:cNvPr>
          <p:cNvSpPr/>
          <p:nvPr/>
        </p:nvSpPr>
        <p:spPr>
          <a:xfrm>
            <a:off x="2220117" y="4513557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0" name="Retângulo 59">
            <a:extLst>
              <a:ext uri="{FF2B5EF4-FFF2-40B4-BE49-F238E27FC236}">
                <a16:creationId xmlns:a16="http://schemas.microsoft.com/office/drawing/2014/main" id="{BA533F96-DE88-B0D4-3B85-23D11241C547}"/>
              </a:ext>
            </a:extLst>
          </p:cNvPr>
          <p:cNvSpPr/>
          <p:nvPr/>
        </p:nvSpPr>
        <p:spPr>
          <a:xfrm>
            <a:off x="2813191" y="4513557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1" name="CaixaDeTexto 60">
            <a:extLst>
              <a:ext uri="{FF2B5EF4-FFF2-40B4-BE49-F238E27FC236}">
                <a16:creationId xmlns:a16="http://schemas.microsoft.com/office/drawing/2014/main" id="{CAA8B8F2-C02D-945C-D23B-3A126F4CC37E}"/>
              </a:ext>
            </a:extLst>
          </p:cNvPr>
          <p:cNvSpPr txBox="1"/>
          <p:nvPr/>
        </p:nvSpPr>
        <p:spPr>
          <a:xfrm rot="19713171">
            <a:off x="3592241" y="3952691"/>
            <a:ext cx="15147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+LPS</a:t>
            </a:r>
            <a:endParaRPr lang="pt-PT" dirty="0"/>
          </a:p>
        </p:txBody>
      </p:sp>
      <p:sp>
        <p:nvSpPr>
          <p:cNvPr id="62" name="Retângulo 61">
            <a:extLst>
              <a:ext uri="{FF2B5EF4-FFF2-40B4-BE49-F238E27FC236}">
                <a16:creationId xmlns:a16="http://schemas.microsoft.com/office/drawing/2014/main" id="{43DAD0AF-E7AE-A023-B061-06F2863C3EF8}"/>
              </a:ext>
            </a:extLst>
          </p:cNvPr>
          <p:cNvSpPr/>
          <p:nvPr/>
        </p:nvSpPr>
        <p:spPr>
          <a:xfrm>
            <a:off x="9199201" y="4378858"/>
            <a:ext cx="447664" cy="1856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3" name="CaixaDeTexto 62">
            <a:extLst>
              <a:ext uri="{FF2B5EF4-FFF2-40B4-BE49-F238E27FC236}">
                <a16:creationId xmlns:a16="http://schemas.microsoft.com/office/drawing/2014/main" id="{55154B51-0246-A88E-B1BC-94C337247D06}"/>
              </a:ext>
            </a:extLst>
          </p:cNvPr>
          <p:cNvSpPr txBox="1"/>
          <p:nvPr/>
        </p:nvSpPr>
        <p:spPr>
          <a:xfrm rot="19713171">
            <a:off x="7698151" y="4035789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Ctr</a:t>
            </a:r>
            <a:endParaRPr lang="pt-PT" dirty="0"/>
          </a:p>
        </p:txBody>
      </p:sp>
      <p:sp>
        <p:nvSpPr>
          <p:cNvPr id="64" name="CaixaDeTexto 63">
            <a:extLst>
              <a:ext uri="{FF2B5EF4-FFF2-40B4-BE49-F238E27FC236}">
                <a16:creationId xmlns:a16="http://schemas.microsoft.com/office/drawing/2014/main" id="{D9C9B98F-7541-49B7-3C4E-B5F6CF5E3F52}"/>
              </a:ext>
            </a:extLst>
          </p:cNvPr>
          <p:cNvSpPr txBox="1"/>
          <p:nvPr/>
        </p:nvSpPr>
        <p:spPr>
          <a:xfrm rot="19713171">
            <a:off x="8410252" y="4045759"/>
            <a:ext cx="56488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LPS</a:t>
            </a:r>
            <a:endParaRPr lang="pt-PT" dirty="0"/>
          </a:p>
        </p:txBody>
      </p:sp>
      <p:sp>
        <p:nvSpPr>
          <p:cNvPr id="65" name="Retângulo 64">
            <a:extLst>
              <a:ext uri="{FF2B5EF4-FFF2-40B4-BE49-F238E27FC236}">
                <a16:creationId xmlns:a16="http://schemas.microsoft.com/office/drawing/2014/main" id="{F9CDC6E1-CB12-3E86-5E72-51CD90BD38B6}"/>
              </a:ext>
            </a:extLst>
          </p:cNvPr>
          <p:cNvSpPr/>
          <p:nvPr/>
        </p:nvSpPr>
        <p:spPr>
          <a:xfrm>
            <a:off x="7772520" y="4335081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6" name="Retângulo 65">
            <a:extLst>
              <a:ext uri="{FF2B5EF4-FFF2-40B4-BE49-F238E27FC236}">
                <a16:creationId xmlns:a16="http://schemas.microsoft.com/office/drawing/2014/main" id="{5F89884E-1995-4957-56E1-D1882FB1FD30}"/>
              </a:ext>
            </a:extLst>
          </p:cNvPr>
          <p:cNvSpPr/>
          <p:nvPr/>
        </p:nvSpPr>
        <p:spPr>
          <a:xfrm>
            <a:off x="8477708" y="4353369"/>
            <a:ext cx="208074" cy="1928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67" name="CaixaDeTexto 66">
            <a:extLst>
              <a:ext uri="{FF2B5EF4-FFF2-40B4-BE49-F238E27FC236}">
                <a16:creationId xmlns:a16="http://schemas.microsoft.com/office/drawing/2014/main" id="{580E1B19-8741-C221-C7FC-F0C695EF5795}"/>
              </a:ext>
            </a:extLst>
          </p:cNvPr>
          <p:cNvSpPr txBox="1"/>
          <p:nvPr/>
        </p:nvSpPr>
        <p:spPr>
          <a:xfrm rot="19713171">
            <a:off x="9071039" y="3842467"/>
            <a:ext cx="1263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</a:t>
            </a:r>
            <a:endParaRPr lang="pt-PT" dirty="0"/>
          </a:p>
        </p:txBody>
      </p:sp>
      <p:sp>
        <p:nvSpPr>
          <p:cNvPr id="68" name="CaixaDeTexto 67">
            <a:extLst>
              <a:ext uri="{FF2B5EF4-FFF2-40B4-BE49-F238E27FC236}">
                <a16:creationId xmlns:a16="http://schemas.microsoft.com/office/drawing/2014/main" id="{6A46F3E8-AFFB-D8B2-0A57-AA2772F1CA0F}"/>
              </a:ext>
            </a:extLst>
          </p:cNvPr>
          <p:cNvSpPr txBox="1"/>
          <p:nvPr/>
        </p:nvSpPr>
        <p:spPr>
          <a:xfrm rot="19713171">
            <a:off x="9311133" y="3814522"/>
            <a:ext cx="15147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pt-PT" sz="12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+mn-cs"/>
              </a:rPr>
              <a:t>Indomethacin+LPS</a:t>
            </a:r>
            <a:endParaRPr lang="pt-PT" dirty="0"/>
          </a:p>
        </p:txBody>
      </p:sp>
      <p:sp>
        <p:nvSpPr>
          <p:cNvPr id="69" name="CaixaDeTexto 68">
            <a:extLst>
              <a:ext uri="{FF2B5EF4-FFF2-40B4-BE49-F238E27FC236}">
                <a16:creationId xmlns:a16="http://schemas.microsoft.com/office/drawing/2014/main" id="{F3FF1298-C704-B5E6-D40B-49F611AD02A5}"/>
              </a:ext>
            </a:extLst>
          </p:cNvPr>
          <p:cNvSpPr txBox="1"/>
          <p:nvPr/>
        </p:nvSpPr>
        <p:spPr>
          <a:xfrm>
            <a:off x="6464332" y="4287461"/>
            <a:ext cx="1296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 err="1"/>
              <a:t>Tubulin</a:t>
            </a:r>
            <a:r>
              <a:rPr lang="pt-PT" sz="1200" b="1" dirty="0"/>
              <a:t> (50 </a:t>
            </a:r>
            <a:r>
              <a:rPr lang="pt-PT" sz="1200" b="1" dirty="0" err="1"/>
              <a:t>kDa</a:t>
            </a:r>
            <a:r>
              <a:rPr lang="pt-PT" sz="1200" b="1" dirty="0"/>
              <a:t>)</a:t>
            </a:r>
          </a:p>
        </p:txBody>
      </p:sp>
      <p:sp>
        <p:nvSpPr>
          <p:cNvPr id="70" name="CaixaDeTexto 69">
            <a:extLst>
              <a:ext uri="{FF2B5EF4-FFF2-40B4-BE49-F238E27FC236}">
                <a16:creationId xmlns:a16="http://schemas.microsoft.com/office/drawing/2014/main" id="{091ECF5A-2689-4184-6B17-830F73C50A33}"/>
              </a:ext>
            </a:extLst>
          </p:cNvPr>
          <p:cNvSpPr txBox="1"/>
          <p:nvPr/>
        </p:nvSpPr>
        <p:spPr>
          <a:xfrm>
            <a:off x="1177830" y="4092944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/>
              <a:t>75 </a:t>
            </a:r>
            <a:r>
              <a:rPr lang="pt-PT" sz="1200" b="1" dirty="0" err="1"/>
              <a:t>kDa</a:t>
            </a:r>
            <a:endParaRPr lang="pt-PT" sz="1200" b="1" dirty="0"/>
          </a:p>
        </p:txBody>
      </p:sp>
      <p:cxnSp>
        <p:nvCxnSpPr>
          <p:cNvPr id="71" name="Conexão reta 70">
            <a:extLst>
              <a:ext uri="{FF2B5EF4-FFF2-40B4-BE49-F238E27FC236}">
                <a16:creationId xmlns:a16="http://schemas.microsoft.com/office/drawing/2014/main" id="{542DF11B-EA2D-1F6F-87D2-576F82279D2C}"/>
              </a:ext>
            </a:extLst>
          </p:cNvPr>
          <p:cNvCxnSpPr>
            <a:cxnSpLocks/>
          </p:cNvCxnSpPr>
          <p:nvPr/>
        </p:nvCxnSpPr>
        <p:spPr>
          <a:xfrm>
            <a:off x="1828836" y="4231444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2" name="CaixaDeTexto 71">
            <a:extLst>
              <a:ext uri="{FF2B5EF4-FFF2-40B4-BE49-F238E27FC236}">
                <a16:creationId xmlns:a16="http://schemas.microsoft.com/office/drawing/2014/main" id="{2967C40E-41D0-F698-505E-72DB88486B35}"/>
              </a:ext>
            </a:extLst>
          </p:cNvPr>
          <p:cNvSpPr txBox="1"/>
          <p:nvPr/>
        </p:nvSpPr>
        <p:spPr>
          <a:xfrm>
            <a:off x="6826745" y="1146443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/>
              <a:t>75 </a:t>
            </a:r>
            <a:r>
              <a:rPr lang="pt-PT" sz="1200" b="1" dirty="0" err="1"/>
              <a:t>kDa</a:t>
            </a:r>
            <a:endParaRPr lang="pt-PT" sz="1200" b="1" dirty="0"/>
          </a:p>
        </p:txBody>
      </p:sp>
      <p:cxnSp>
        <p:nvCxnSpPr>
          <p:cNvPr id="73" name="Conexão reta 72">
            <a:extLst>
              <a:ext uri="{FF2B5EF4-FFF2-40B4-BE49-F238E27FC236}">
                <a16:creationId xmlns:a16="http://schemas.microsoft.com/office/drawing/2014/main" id="{8FCAA288-4157-B2BA-F9C3-5188BBC899CD}"/>
              </a:ext>
            </a:extLst>
          </p:cNvPr>
          <p:cNvCxnSpPr>
            <a:cxnSpLocks/>
          </p:cNvCxnSpPr>
          <p:nvPr/>
        </p:nvCxnSpPr>
        <p:spPr>
          <a:xfrm>
            <a:off x="7477751" y="1284943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4" name="CaixaDeTexto 73">
            <a:extLst>
              <a:ext uri="{FF2B5EF4-FFF2-40B4-BE49-F238E27FC236}">
                <a16:creationId xmlns:a16="http://schemas.microsoft.com/office/drawing/2014/main" id="{55C97C01-7E44-79DD-D8C0-5EFA2694FEE6}"/>
              </a:ext>
            </a:extLst>
          </p:cNvPr>
          <p:cNvSpPr txBox="1"/>
          <p:nvPr/>
        </p:nvSpPr>
        <p:spPr>
          <a:xfrm>
            <a:off x="6927897" y="3959620"/>
            <a:ext cx="655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1200" b="1" dirty="0"/>
              <a:t>75 </a:t>
            </a:r>
            <a:r>
              <a:rPr lang="pt-PT" sz="1200" b="1" dirty="0" err="1"/>
              <a:t>kDa</a:t>
            </a:r>
            <a:endParaRPr lang="pt-PT" sz="1200" b="1" dirty="0"/>
          </a:p>
        </p:txBody>
      </p:sp>
      <p:cxnSp>
        <p:nvCxnSpPr>
          <p:cNvPr id="75" name="Conexão reta 74">
            <a:extLst>
              <a:ext uri="{FF2B5EF4-FFF2-40B4-BE49-F238E27FC236}">
                <a16:creationId xmlns:a16="http://schemas.microsoft.com/office/drawing/2014/main" id="{BFBC02FC-EBEB-535A-F26B-D39B58DE98DF}"/>
              </a:ext>
            </a:extLst>
          </p:cNvPr>
          <p:cNvCxnSpPr>
            <a:cxnSpLocks/>
          </p:cNvCxnSpPr>
          <p:nvPr/>
        </p:nvCxnSpPr>
        <p:spPr>
          <a:xfrm>
            <a:off x="7578903" y="4098120"/>
            <a:ext cx="13271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76" name="Imagem 75">
            <a:extLst>
              <a:ext uri="{FF2B5EF4-FFF2-40B4-BE49-F238E27FC236}">
                <a16:creationId xmlns:a16="http://schemas.microsoft.com/office/drawing/2014/main" id="{A351E1F1-7AF7-B23A-985C-514F1B72A51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92" r="68979"/>
          <a:stretch/>
        </p:blipFill>
        <p:spPr>
          <a:xfrm>
            <a:off x="202115" y="820019"/>
            <a:ext cx="655731" cy="2051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97650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04</TotalTime>
  <Words>2031</Words>
  <Application>Microsoft Office PowerPoint</Application>
  <PresentationFormat>Ecrã Panorâmico</PresentationFormat>
  <Paragraphs>218</Paragraphs>
  <Slides>17</Slides>
  <Notes>4</Notes>
  <HiddenSlides>0</HiddenSlides>
  <MMClips>0</MMClips>
  <ScaleCrop>false</ScaleCrop>
  <HeadingPairs>
    <vt:vector size="8" baseType="variant">
      <vt:variant>
        <vt:lpstr>Tipos de letra usado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orporados</vt:lpstr>
      </vt:variant>
      <vt:variant>
        <vt:i4>1</vt:i4>
      </vt:variant>
      <vt:variant>
        <vt:lpstr>Títulos dos diapositivos</vt:lpstr>
      </vt:variant>
      <vt:variant>
        <vt:i4>17</vt:i4>
      </vt:variant>
    </vt:vector>
  </HeadingPairs>
  <TitlesOfParts>
    <vt:vector size="24" baseType="lpstr">
      <vt:lpstr>Aptos</vt:lpstr>
      <vt:lpstr>Aptos Display</vt:lpstr>
      <vt:lpstr>Arial</vt:lpstr>
      <vt:lpstr>Calibri</vt:lpstr>
      <vt:lpstr>Times New Roman</vt:lpstr>
      <vt:lpstr>Tema do Office</vt:lpstr>
      <vt:lpstr>Prism 8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Cristina Rosa da Silva</dc:creator>
  <cp:lastModifiedBy>Ana Silva</cp:lastModifiedBy>
  <cp:revision>157</cp:revision>
  <dcterms:created xsi:type="dcterms:W3CDTF">2024-10-19T08:20:24Z</dcterms:created>
  <dcterms:modified xsi:type="dcterms:W3CDTF">2026-05-20T13:31:15Z</dcterms:modified>
</cp:coreProperties>
</file>